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92" autoAdjust="0"/>
    <p:restoredTop sz="94660"/>
  </p:normalViewPr>
  <p:slideViewPr>
    <p:cSldViewPr snapToGrid="0">
      <p:cViewPr varScale="1">
        <p:scale>
          <a:sx n="56" d="100"/>
          <a:sy n="56" d="100"/>
        </p:scale>
        <p:origin x="36" y="47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4B576F-3BED-4FF9-A4AF-8AFF28619FDE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A6EE1C-0E8C-493F-9D57-66F321CAA8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4256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89FCD1DD-075D-44F5-8837-12AEBE09E2A2}" type="slidenum">
              <a:rPr lang="it-IT" altLang="en-US"/>
              <a:pPr/>
              <a:t>1</a:t>
            </a:fld>
            <a:endParaRPr lang="it-IT" altLang="en-US"/>
          </a:p>
        </p:txBody>
      </p:sp>
      <p:sp>
        <p:nvSpPr>
          <p:cNvPr id="2150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789238" y="573088"/>
            <a:ext cx="4646612" cy="2614612"/>
          </a:xfrm>
          <a:ln/>
        </p:spPr>
      </p:sp>
      <p:sp>
        <p:nvSpPr>
          <p:cNvPr id="2150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1362062" y="3657601"/>
            <a:ext cx="7495911" cy="3470672"/>
          </a:xfrm>
        </p:spPr>
        <p:txBody>
          <a:bodyPr/>
          <a:lstStyle/>
          <a:p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855969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CA1070-B90E-4FAF-A3D2-241EC2723C9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13ED97-9A45-4AC1-A17D-B38653BFA6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F494BB-0EF2-44D8-9636-92B9C07F6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62346A-3CC8-49FE-B8F4-A3C19C3CA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B6D55F-7790-49BD-BABC-10CBE3437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9259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EFBCC-B105-49FF-9F57-31F751931B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49708B-1888-41AA-83DC-89AB04CE72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D4C6ED-08B0-4570-B6C4-C3358FD01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CB5D4-9C44-43F3-93C5-47C118B1F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1F08F7-EE11-4530-A22C-274BBA864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4328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C27784-F263-46A3-B6A6-360AA8F904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D5DFD4-CBC1-4768-AA1B-71C8AE2926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F7C1BA-5015-4896-9108-E4F4BCDB2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69FE6E-57B1-492C-BF79-E75F213A6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A8077-21EA-4863-AACF-36AAB091A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956978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L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u="sng">
                <a:latin typeface="+mn-lt"/>
              </a:defRPr>
            </a:lvl1pPr>
          </a:lstStyle>
          <a:p>
            <a:r>
              <a:rPr lang="en-US" dirty="0"/>
              <a:t>CC-BY-NC-ND Roberto Merletti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B363E4B2-0888-47DE-8A88-D22F6862BD51}" type="slidenum">
              <a:rPr lang="en-US" smtClean="0"/>
              <a:pPr/>
              <a:t>‹#›</a:t>
            </a:fld>
            <a:r>
              <a:rPr lang="en-US" dirty="0"/>
              <a:t> of 49</a:t>
            </a:r>
          </a:p>
        </p:txBody>
      </p:sp>
    </p:spTree>
    <p:extLst>
      <p:ext uri="{BB962C8B-B14F-4D97-AF65-F5344CB8AC3E}">
        <p14:creationId xmlns:p14="http://schemas.microsoft.com/office/powerpoint/2010/main" val="1187980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57279C-4670-40D9-BF26-9CAB7F33D2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031DC4-F07E-4B77-8066-EE1879E3BF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05449A-FD2C-430B-85DE-A0F6F222E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2CDB72-416F-49DC-BE0A-DC23E7E96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0F5437-190B-4F35-822C-A4E07EE3F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5703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04E68-53D2-4084-8F49-B2B011B063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AFAD2D-654F-417B-81A9-50C5546BAB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952E1A-D9CC-4A9A-BB6E-D42C844D3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E5F11-FB80-4F25-BA30-3D39DA9EE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009DF4-BA43-4514-868C-3F8F7CF70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4904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9FD1BD-5997-4790-B2E3-746EFD23AD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C96D6B-E56E-453F-BEAE-C5116D4992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67AC1F-12C3-40B8-BBBE-6D92DAEE73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AF4890-3296-4BEB-BBED-650F8568C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AE4672-39A3-4436-9E9C-943172199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F02524-BF3B-407A-ADC8-E4AB92E8F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2916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BF4535-B172-4EEC-9FDF-55A9128E3C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12BCDE-2603-4FBE-A093-94117EBFFF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A6E77F-32FB-4955-A7B3-8FCA05A6B8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6CF472-2F89-45DE-AC81-D5E231D8AA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2821A9-5D35-4682-9A71-29114A0FD9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8ADE74-746B-4610-BD59-A28203BA3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255D138-D992-4A42-94A2-F0F4CEBADD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9EE46D-7854-4527-A0DB-A9ABB51AC6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5297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ECF369-232A-44BA-921F-B8C98F3570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B8072DA-BF73-4FCB-8FC2-9342C8228C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D50928B-2FAE-4DBF-ADF7-BF6DCAB0D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1480CA-A382-4B75-8BCD-31A7A453A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7091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0557E71-E612-4B8B-BE3E-EB7B93E91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934A9D-CE61-48BE-AF78-0F881ED94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B5DA76-787C-492F-9806-F0E60DBCA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3892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64B4F-DA7B-4C9E-949E-051022340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291FE1-4730-4490-A518-023EDC092A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B56A68-E58A-40EF-BA60-59F43FFBA9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39F824-F74B-41C3-92AB-1AF774E2E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B967B4-D0FA-42C0-A49D-F253B0DF7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334E07-D803-44D8-9122-CAAEE31AC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3297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5326BB-A2AC-4993-B719-8020143A6B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7FE860-33E7-4C6F-BE9F-BFC46C609A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91A74B-7F1E-45A0-9862-F2FDC5C6C9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743960-92E0-410D-BD26-4B6B4475C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5261CF-6A43-43C8-A9D4-1C311DE04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DE34C4-D2DD-49AA-956C-32E7F6C6B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2029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514162F-F676-4BA3-A0D9-8DC1ED9D20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506E2E-AB73-4B71-8652-0AF0C5A946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E686E7-9D37-4838-83FE-03A71E9521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B80EF-40FD-474A-9663-14D20835B94D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627829-2E7F-4F6B-8B32-1FCF2136F5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A30715-4D1A-40E5-ADC9-3D339EE708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A6803-7E86-431C-8C18-C452CD4EC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7845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2"/>
          <p:cNvSpPr>
            <a:spLocks noChangeArrowheads="1"/>
          </p:cNvSpPr>
          <p:nvPr/>
        </p:nvSpPr>
        <p:spPr bwMode="auto">
          <a:xfrm>
            <a:off x="0" y="4003623"/>
            <a:ext cx="10515600" cy="596900"/>
          </a:xfrm>
          <a:prstGeom prst="rect">
            <a:avLst/>
          </a:prstGeom>
          <a:solidFill>
            <a:srgbClr val="FFFFCC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r>
              <a:rPr lang="en-US" dirty="0"/>
              <a:t> </a:t>
            </a:r>
          </a:p>
        </p:txBody>
      </p:sp>
      <p:sp>
        <p:nvSpPr>
          <p:cNvPr id="20483" name="Rectangle 3" descr="Linee verticali tratteggiate"/>
          <p:cNvSpPr>
            <a:spLocks noChangeArrowheads="1"/>
          </p:cNvSpPr>
          <p:nvPr/>
        </p:nvSpPr>
        <p:spPr bwMode="auto">
          <a:xfrm>
            <a:off x="3840164" y="4613223"/>
            <a:ext cx="681037" cy="1062038"/>
          </a:xfrm>
          <a:prstGeom prst="rect">
            <a:avLst/>
          </a:prstGeom>
          <a:pattFill prst="dashVert">
            <a:fgClr>
              <a:srgbClr val="33CC33"/>
            </a:fgClr>
            <a:bgClr>
              <a:schemeClr val="bg1"/>
            </a:bgClr>
          </a:pattFill>
          <a:ln>
            <a:noFill/>
          </a:ln>
          <a:effectLst/>
          <a:extLs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484" name="AutoShape 4"/>
          <p:cNvSpPr>
            <a:spLocks noChangeArrowheads="1"/>
          </p:cNvSpPr>
          <p:nvPr/>
        </p:nvSpPr>
        <p:spPr bwMode="auto">
          <a:xfrm>
            <a:off x="0" y="5618111"/>
            <a:ext cx="9634538" cy="109978"/>
          </a:xfrm>
          <a:prstGeom prst="roundRect">
            <a:avLst>
              <a:gd name="adj" fmla="val 16667"/>
            </a:avLst>
          </a:prstGeom>
          <a:noFill/>
          <a:ln w="12700">
            <a:solidFill>
              <a:srgbClr val="CE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485" name="AutoShape 5"/>
          <p:cNvSpPr>
            <a:spLocks noChangeArrowheads="1"/>
          </p:cNvSpPr>
          <p:nvPr/>
        </p:nvSpPr>
        <p:spPr bwMode="auto">
          <a:xfrm>
            <a:off x="0" y="4848173"/>
            <a:ext cx="10052050" cy="114300"/>
          </a:xfrm>
          <a:prstGeom prst="roundRect">
            <a:avLst>
              <a:gd name="adj" fmla="val 16667"/>
            </a:avLst>
          </a:prstGeom>
          <a:noFill/>
          <a:ln w="12700">
            <a:solidFill>
              <a:srgbClr val="CE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488" name="Rectangle 8"/>
          <p:cNvSpPr>
            <a:spLocks noChangeArrowheads="1"/>
          </p:cNvSpPr>
          <p:nvPr/>
        </p:nvSpPr>
        <p:spPr bwMode="auto">
          <a:xfrm>
            <a:off x="526670" y="4016331"/>
            <a:ext cx="2222880" cy="339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91041" tIns="46292" rIns="91041" bIns="46292">
            <a:spAutoFit/>
          </a:bodyPr>
          <a:lstStyle>
            <a:lvl1pPr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4025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08050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60488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12925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701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273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1845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417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600" b="1" dirty="0"/>
              <a:t>subcutaneous tissue</a:t>
            </a:r>
          </a:p>
        </p:txBody>
      </p:sp>
      <p:sp>
        <p:nvSpPr>
          <p:cNvPr id="20492" name="Oval 12"/>
          <p:cNvSpPr>
            <a:spLocks noChangeArrowheads="1"/>
          </p:cNvSpPr>
          <p:nvPr/>
        </p:nvSpPr>
        <p:spPr bwMode="auto">
          <a:xfrm>
            <a:off x="4273550" y="4829123"/>
            <a:ext cx="139700" cy="139700"/>
          </a:xfrm>
          <a:prstGeom prst="ellipse">
            <a:avLst/>
          </a:prstGeom>
          <a:solidFill>
            <a:schemeClr val="tx2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493" name="Oval 13"/>
          <p:cNvSpPr>
            <a:spLocks noChangeArrowheads="1"/>
          </p:cNvSpPr>
          <p:nvPr/>
        </p:nvSpPr>
        <p:spPr bwMode="auto">
          <a:xfrm>
            <a:off x="3816350" y="5600648"/>
            <a:ext cx="139700" cy="139700"/>
          </a:xfrm>
          <a:prstGeom prst="ellipse">
            <a:avLst/>
          </a:prstGeom>
          <a:solidFill>
            <a:schemeClr val="tx2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494" name="Rectangle 14"/>
          <p:cNvSpPr>
            <a:spLocks noChangeArrowheads="1"/>
          </p:cNvSpPr>
          <p:nvPr/>
        </p:nvSpPr>
        <p:spPr bwMode="auto">
          <a:xfrm>
            <a:off x="5111750" y="4848173"/>
            <a:ext cx="749300" cy="101600"/>
          </a:xfrm>
          <a:prstGeom prst="rect">
            <a:avLst/>
          </a:prstGeom>
          <a:solidFill>
            <a:srgbClr val="FF0000"/>
          </a:solidFill>
          <a:ln w="1270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495" name="Rectangle 15"/>
          <p:cNvSpPr>
            <a:spLocks noChangeArrowheads="1"/>
          </p:cNvSpPr>
          <p:nvPr/>
        </p:nvSpPr>
        <p:spPr bwMode="auto">
          <a:xfrm>
            <a:off x="2749550" y="4848173"/>
            <a:ext cx="749300" cy="101600"/>
          </a:xfrm>
          <a:prstGeom prst="rect">
            <a:avLst/>
          </a:prstGeom>
          <a:solidFill>
            <a:srgbClr val="FF0000"/>
          </a:solidFill>
          <a:ln w="1270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496" name="Rectangle 16"/>
          <p:cNvSpPr>
            <a:spLocks noChangeArrowheads="1"/>
          </p:cNvSpPr>
          <p:nvPr/>
        </p:nvSpPr>
        <p:spPr bwMode="auto">
          <a:xfrm>
            <a:off x="2368550" y="5610173"/>
            <a:ext cx="749300" cy="101600"/>
          </a:xfrm>
          <a:prstGeom prst="rect">
            <a:avLst/>
          </a:prstGeom>
          <a:solidFill>
            <a:srgbClr val="FF0000"/>
          </a:solidFill>
          <a:ln w="1270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497" name="Rectangle 17"/>
          <p:cNvSpPr>
            <a:spLocks noChangeArrowheads="1"/>
          </p:cNvSpPr>
          <p:nvPr/>
        </p:nvSpPr>
        <p:spPr bwMode="auto">
          <a:xfrm>
            <a:off x="4881563" y="5595886"/>
            <a:ext cx="749300" cy="101600"/>
          </a:xfrm>
          <a:prstGeom prst="rect">
            <a:avLst/>
          </a:prstGeom>
          <a:solidFill>
            <a:srgbClr val="FF0000"/>
          </a:solidFill>
          <a:ln w="1270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07" name="Rectangle 27"/>
          <p:cNvSpPr>
            <a:spLocks noChangeArrowheads="1"/>
          </p:cNvSpPr>
          <p:nvPr/>
        </p:nvSpPr>
        <p:spPr bwMode="auto">
          <a:xfrm>
            <a:off x="3529210" y="6029036"/>
            <a:ext cx="1288059" cy="5859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91041" tIns="46292" rIns="91041" bIns="46292">
            <a:spAutoFit/>
          </a:bodyPr>
          <a:lstStyle>
            <a:lvl1pPr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4025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08050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60488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12925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701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273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1845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417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0" hangingPunct="0"/>
            <a:r>
              <a:rPr lang="en-US" altLang="en-US" sz="1600" b="1" dirty="0"/>
              <a:t>innervation </a:t>
            </a:r>
          </a:p>
          <a:p>
            <a:pPr algn="ctr" eaLnBrk="0" hangingPunct="0"/>
            <a:r>
              <a:rPr lang="en-US" altLang="en-US" sz="1600" b="1" dirty="0"/>
              <a:t>zone (IZ)</a:t>
            </a:r>
          </a:p>
        </p:txBody>
      </p:sp>
      <p:sp>
        <p:nvSpPr>
          <p:cNvPr id="20508" name="Rectangle 28"/>
          <p:cNvSpPr>
            <a:spLocks noChangeArrowheads="1"/>
          </p:cNvSpPr>
          <p:nvPr/>
        </p:nvSpPr>
        <p:spPr bwMode="auto">
          <a:xfrm>
            <a:off x="9027192" y="5821312"/>
            <a:ext cx="1504735" cy="524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91041" tIns="46292" rIns="91041" bIns="46292">
            <a:spAutoFit/>
          </a:bodyPr>
          <a:lstStyle>
            <a:lvl1pPr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4025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08050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60488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12925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701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273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1845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417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 dirty="0"/>
              <a:t>muscle-tendon </a:t>
            </a:r>
          </a:p>
          <a:p>
            <a:pPr eaLnBrk="0" hangingPunct="0"/>
            <a:r>
              <a:rPr lang="en-US" altLang="en-US" sz="1400" b="1" dirty="0"/>
              <a:t>junctions</a:t>
            </a:r>
          </a:p>
        </p:txBody>
      </p:sp>
      <p:sp>
        <p:nvSpPr>
          <p:cNvPr id="20509" name="AutoShape 29"/>
          <p:cNvSpPr>
            <a:spLocks noChangeArrowheads="1"/>
          </p:cNvSpPr>
          <p:nvPr/>
        </p:nvSpPr>
        <p:spPr bwMode="auto">
          <a:xfrm>
            <a:off x="0" y="5233935"/>
            <a:ext cx="10356850" cy="115887"/>
          </a:xfrm>
          <a:prstGeom prst="roundRect">
            <a:avLst>
              <a:gd name="adj" fmla="val 16667"/>
            </a:avLst>
          </a:prstGeom>
          <a:noFill/>
          <a:ln w="12700">
            <a:solidFill>
              <a:srgbClr val="CE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10" name="Rectangle 30"/>
          <p:cNvSpPr>
            <a:spLocks noChangeArrowheads="1"/>
          </p:cNvSpPr>
          <p:nvPr/>
        </p:nvSpPr>
        <p:spPr bwMode="auto">
          <a:xfrm>
            <a:off x="5187950" y="5229173"/>
            <a:ext cx="749300" cy="101600"/>
          </a:xfrm>
          <a:prstGeom prst="rect">
            <a:avLst/>
          </a:prstGeom>
          <a:solidFill>
            <a:srgbClr val="FF0000"/>
          </a:solidFill>
          <a:ln w="1270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11" name="Rectangle 31"/>
          <p:cNvSpPr>
            <a:spLocks noChangeArrowheads="1"/>
          </p:cNvSpPr>
          <p:nvPr/>
        </p:nvSpPr>
        <p:spPr bwMode="auto">
          <a:xfrm>
            <a:off x="2825750" y="5233936"/>
            <a:ext cx="749300" cy="93662"/>
          </a:xfrm>
          <a:prstGeom prst="rect">
            <a:avLst/>
          </a:prstGeom>
          <a:solidFill>
            <a:srgbClr val="FF0000"/>
          </a:solidFill>
          <a:ln w="1270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12" name="Oval 32"/>
          <p:cNvSpPr>
            <a:spLocks noChangeArrowheads="1"/>
          </p:cNvSpPr>
          <p:nvPr/>
        </p:nvSpPr>
        <p:spPr bwMode="auto">
          <a:xfrm>
            <a:off x="4425950" y="5219648"/>
            <a:ext cx="139700" cy="139700"/>
          </a:xfrm>
          <a:prstGeom prst="ellipse">
            <a:avLst/>
          </a:prstGeom>
          <a:solidFill>
            <a:schemeClr val="tx2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13" name="Freeform 33"/>
          <p:cNvSpPr>
            <a:spLocks/>
          </p:cNvSpPr>
          <p:nvPr/>
        </p:nvSpPr>
        <p:spPr bwMode="auto">
          <a:xfrm>
            <a:off x="1752601" y="4994223"/>
            <a:ext cx="2601913" cy="1449388"/>
          </a:xfrm>
          <a:custGeom>
            <a:avLst/>
            <a:gdLst>
              <a:gd name="T0" fmla="*/ 1672 w 1673"/>
              <a:gd name="T1" fmla="*/ 18 h 949"/>
              <a:gd name="T2" fmla="*/ 1655 w 1673"/>
              <a:gd name="T3" fmla="*/ 54 h 949"/>
              <a:gd name="T4" fmla="*/ 1650 w 1673"/>
              <a:gd name="T5" fmla="*/ 90 h 949"/>
              <a:gd name="T6" fmla="*/ 1633 w 1673"/>
              <a:gd name="T7" fmla="*/ 126 h 949"/>
              <a:gd name="T8" fmla="*/ 1627 w 1673"/>
              <a:gd name="T9" fmla="*/ 168 h 949"/>
              <a:gd name="T10" fmla="*/ 1616 w 1673"/>
              <a:gd name="T11" fmla="*/ 204 h 949"/>
              <a:gd name="T12" fmla="*/ 1605 w 1673"/>
              <a:gd name="T13" fmla="*/ 240 h 949"/>
              <a:gd name="T14" fmla="*/ 1583 w 1673"/>
              <a:gd name="T15" fmla="*/ 276 h 949"/>
              <a:gd name="T16" fmla="*/ 1560 w 1673"/>
              <a:gd name="T17" fmla="*/ 312 h 949"/>
              <a:gd name="T18" fmla="*/ 1538 w 1673"/>
              <a:gd name="T19" fmla="*/ 348 h 949"/>
              <a:gd name="T20" fmla="*/ 1527 w 1673"/>
              <a:gd name="T21" fmla="*/ 384 h 949"/>
              <a:gd name="T22" fmla="*/ 1510 w 1673"/>
              <a:gd name="T23" fmla="*/ 420 h 949"/>
              <a:gd name="T24" fmla="*/ 1493 w 1673"/>
              <a:gd name="T25" fmla="*/ 456 h 949"/>
              <a:gd name="T26" fmla="*/ 1476 w 1673"/>
              <a:gd name="T27" fmla="*/ 492 h 949"/>
              <a:gd name="T28" fmla="*/ 1454 w 1673"/>
              <a:gd name="T29" fmla="*/ 522 h 949"/>
              <a:gd name="T30" fmla="*/ 1432 w 1673"/>
              <a:gd name="T31" fmla="*/ 552 h 949"/>
              <a:gd name="T32" fmla="*/ 1398 w 1673"/>
              <a:gd name="T33" fmla="*/ 576 h 949"/>
              <a:gd name="T34" fmla="*/ 1364 w 1673"/>
              <a:gd name="T35" fmla="*/ 582 h 949"/>
              <a:gd name="T36" fmla="*/ 1325 w 1673"/>
              <a:gd name="T37" fmla="*/ 588 h 949"/>
              <a:gd name="T38" fmla="*/ 1292 w 1673"/>
              <a:gd name="T39" fmla="*/ 606 h 949"/>
              <a:gd name="T40" fmla="*/ 1258 w 1673"/>
              <a:gd name="T41" fmla="*/ 618 h 949"/>
              <a:gd name="T42" fmla="*/ 1225 w 1673"/>
              <a:gd name="T43" fmla="*/ 630 h 949"/>
              <a:gd name="T44" fmla="*/ 1191 w 1673"/>
              <a:gd name="T45" fmla="*/ 642 h 949"/>
              <a:gd name="T46" fmla="*/ 1158 w 1673"/>
              <a:gd name="T47" fmla="*/ 654 h 949"/>
              <a:gd name="T48" fmla="*/ 1118 w 1673"/>
              <a:gd name="T49" fmla="*/ 666 h 949"/>
              <a:gd name="T50" fmla="*/ 1079 w 1673"/>
              <a:gd name="T51" fmla="*/ 678 h 949"/>
              <a:gd name="T52" fmla="*/ 1046 w 1673"/>
              <a:gd name="T53" fmla="*/ 696 h 949"/>
              <a:gd name="T54" fmla="*/ 1012 w 1673"/>
              <a:gd name="T55" fmla="*/ 702 h 949"/>
              <a:gd name="T56" fmla="*/ 979 w 1673"/>
              <a:gd name="T57" fmla="*/ 714 h 949"/>
              <a:gd name="T58" fmla="*/ 945 w 1673"/>
              <a:gd name="T59" fmla="*/ 726 h 949"/>
              <a:gd name="T60" fmla="*/ 911 w 1673"/>
              <a:gd name="T61" fmla="*/ 738 h 949"/>
              <a:gd name="T62" fmla="*/ 878 w 1673"/>
              <a:gd name="T63" fmla="*/ 750 h 949"/>
              <a:gd name="T64" fmla="*/ 844 w 1673"/>
              <a:gd name="T65" fmla="*/ 756 h 949"/>
              <a:gd name="T66" fmla="*/ 805 w 1673"/>
              <a:gd name="T67" fmla="*/ 768 h 949"/>
              <a:gd name="T68" fmla="*/ 772 w 1673"/>
              <a:gd name="T69" fmla="*/ 774 h 949"/>
              <a:gd name="T70" fmla="*/ 738 w 1673"/>
              <a:gd name="T71" fmla="*/ 780 h 949"/>
              <a:gd name="T72" fmla="*/ 705 w 1673"/>
              <a:gd name="T73" fmla="*/ 792 h 949"/>
              <a:gd name="T74" fmla="*/ 671 w 1673"/>
              <a:gd name="T75" fmla="*/ 798 h 949"/>
              <a:gd name="T76" fmla="*/ 637 w 1673"/>
              <a:gd name="T77" fmla="*/ 810 h 949"/>
              <a:gd name="T78" fmla="*/ 604 w 1673"/>
              <a:gd name="T79" fmla="*/ 816 h 949"/>
              <a:gd name="T80" fmla="*/ 570 w 1673"/>
              <a:gd name="T81" fmla="*/ 822 h 949"/>
              <a:gd name="T82" fmla="*/ 537 w 1673"/>
              <a:gd name="T83" fmla="*/ 822 h 949"/>
              <a:gd name="T84" fmla="*/ 503 w 1673"/>
              <a:gd name="T85" fmla="*/ 834 h 949"/>
              <a:gd name="T86" fmla="*/ 470 w 1673"/>
              <a:gd name="T87" fmla="*/ 846 h 949"/>
              <a:gd name="T88" fmla="*/ 436 w 1673"/>
              <a:gd name="T89" fmla="*/ 846 h 949"/>
              <a:gd name="T90" fmla="*/ 403 w 1673"/>
              <a:gd name="T91" fmla="*/ 858 h 949"/>
              <a:gd name="T92" fmla="*/ 369 w 1673"/>
              <a:gd name="T93" fmla="*/ 870 h 949"/>
              <a:gd name="T94" fmla="*/ 336 w 1673"/>
              <a:gd name="T95" fmla="*/ 870 h 949"/>
              <a:gd name="T96" fmla="*/ 302 w 1673"/>
              <a:gd name="T97" fmla="*/ 882 h 949"/>
              <a:gd name="T98" fmla="*/ 268 w 1673"/>
              <a:gd name="T99" fmla="*/ 894 h 949"/>
              <a:gd name="T100" fmla="*/ 235 w 1673"/>
              <a:gd name="T101" fmla="*/ 894 h 949"/>
              <a:gd name="T102" fmla="*/ 201 w 1673"/>
              <a:gd name="T103" fmla="*/ 906 h 949"/>
              <a:gd name="T104" fmla="*/ 168 w 1673"/>
              <a:gd name="T105" fmla="*/ 918 h 949"/>
              <a:gd name="T106" fmla="*/ 134 w 1673"/>
              <a:gd name="T107" fmla="*/ 924 h 949"/>
              <a:gd name="T108" fmla="*/ 101 w 1673"/>
              <a:gd name="T109" fmla="*/ 936 h 949"/>
              <a:gd name="T110" fmla="*/ 67 w 1673"/>
              <a:gd name="T111" fmla="*/ 942 h 949"/>
              <a:gd name="T112" fmla="*/ 34 w 1673"/>
              <a:gd name="T113" fmla="*/ 942 h 949"/>
              <a:gd name="T114" fmla="*/ 0 w 1673"/>
              <a:gd name="T115" fmla="*/ 948 h 9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1673" h="949">
                <a:moveTo>
                  <a:pt x="1672" y="0"/>
                </a:moveTo>
                <a:lnTo>
                  <a:pt x="1672" y="18"/>
                </a:lnTo>
                <a:lnTo>
                  <a:pt x="1666" y="36"/>
                </a:lnTo>
                <a:lnTo>
                  <a:pt x="1655" y="54"/>
                </a:lnTo>
                <a:lnTo>
                  <a:pt x="1650" y="72"/>
                </a:lnTo>
                <a:lnTo>
                  <a:pt x="1650" y="90"/>
                </a:lnTo>
                <a:lnTo>
                  <a:pt x="1638" y="108"/>
                </a:lnTo>
                <a:lnTo>
                  <a:pt x="1633" y="126"/>
                </a:lnTo>
                <a:lnTo>
                  <a:pt x="1627" y="150"/>
                </a:lnTo>
                <a:lnTo>
                  <a:pt x="1627" y="168"/>
                </a:lnTo>
                <a:lnTo>
                  <a:pt x="1622" y="186"/>
                </a:lnTo>
                <a:lnTo>
                  <a:pt x="1616" y="204"/>
                </a:lnTo>
                <a:lnTo>
                  <a:pt x="1610" y="222"/>
                </a:lnTo>
                <a:lnTo>
                  <a:pt x="1605" y="240"/>
                </a:lnTo>
                <a:lnTo>
                  <a:pt x="1594" y="258"/>
                </a:lnTo>
                <a:lnTo>
                  <a:pt x="1583" y="276"/>
                </a:lnTo>
                <a:lnTo>
                  <a:pt x="1571" y="294"/>
                </a:lnTo>
                <a:lnTo>
                  <a:pt x="1560" y="312"/>
                </a:lnTo>
                <a:lnTo>
                  <a:pt x="1549" y="330"/>
                </a:lnTo>
                <a:lnTo>
                  <a:pt x="1538" y="348"/>
                </a:lnTo>
                <a:lnTo>
                  <a:pt x="1538" y="366"/>
                </a:lnTo>
                <a:lnTo>
                  <a:pt x="1527" y="384"/>
                </a:lnTo>
                <a:lnTo>
                  <a:pt x="1515" y="402"/>
                </a:lnTo>
                <a:lnTo>
                  <a:pt x="1510" y="420"/>
                </a:lnTo>
                <a:lnTo>
                  <a:pt x="1504" y="438"/>
                </a:lnTo>
                <a:lnTo>
                  <a:pt x="1493" y="456"/>
                </a:lnTo>
                <a:lnTo>
                  <a:pt x="1487" y="474"/>
                </a:lnTo>
                <a:lnTo>
                  <a:pt x="1476" y="492"/>
                </a:lnTo>
                <a:lnTo>
                  <a:pt x="1471" y="510"/>
                </a:lnTo>
                <a:lnTo>
                  <a:pt x="1454" y="522"/>
                </a:lnTo>
                <a:lnTo>
                  <a:pt x="1448" y="540"/>
                </a:lnTo>
                <a:lnTo>
                  <a:pt x="1432" y="552"/>
                </a:lnTo>
                <a:lnTo>
                  <a:pt x="1415" y="564"/>
                </a:lnTo>
                <a:lnTo>
                  <a:pt x="1398" y="576"/>
                </a:lnTo>
                <a:lnTo>
                  <a:pt x="1381" y="582"/>
                </a:lnTo>
                <a:lnTo>
                  <a:pt x="1364" y="582"/>
                </a:lnTo>
                <a:lnTo>
                  <a:pt x="1342" y="588"/>
                </a:lnTo>
                <a:lnTo>
                  <a:pt x="1325" y="588"/>
                </a:lnTo>
                <a:lnTo>
                  <a:pt x="1309" y="600"/>
                </a:lnTo>
                <a:lnTo>
                  <a:pt x="1292" y="606"/>
                </a:lnTo>
                <a:lnTo>
                  <a:pt x="1275" y="612"/>
                </a:lnTo>
                <a:lnTo>
                  <a:pt x="1258" y="618"/>
                </a:lnTo>
                <a:lnTo>
                  <a:pt x="1241" y="624"/>
                </a:lnTo>
                <a:lnTo>
                  <a:pt x="1225" y="630"/>
                </a:lnTo>
                <a:lnTo>
                  <a:pt x="1208" y="636"/>
                </a:lnTo>
                <a:lnTo>
                  <a:pt x="1191" y="642"/>
                </a:lnTo>
                <a:lnTo>
                  <a:pt x="1174" y="654"/>
                </a:lnTo>
                <a:lnTo>
                  <a:pt x="1158" y="654"/>
                </a:lnTo>
                <a:lnTo>
                  <a:pt x="1135" y="660"/>
                </a:lnTo>
                <a:lnTo>
                  <a:pt x="1118" y="666"/>
                </a:lnTo>
                <a:lnTo>
                  <a:pt x="1096" y="678"/>
                </a:lnTo>
                <a:lnTo>
                  <a:pt x="1079" y="678"/>
                </a:lnTo>
                <a:lnTo>
                  <a:pt x="1062" y="690"/>
                </a:lnTo>
                <a:lnTo>
                  <a:pt x="1046" y="696"/>
                </a:lnTo>
                <a:lnTo>
                  <a:pt x="1029" y="702"/>
                </a:lnTo>
                <a:lnTo>
                  <a:pt x="1012" y="702"/>
                </a:lnTo>
                <a:lnTo>
                  <a:pt x="995" y="708"/>
                </a:lnTo>
                <a:lnTo>
                  <a:pt x="979" y="714"/>
                </a:lnTo>
                <a:lnTo>
                  <a:pt x="962" y="720"/>
                </a:lnTo>
                <a:lnTo>
                  <a:pt x="945" y="726"/>
                </a:lnTo>
                <a:lnTo>
                  <a:pt x="928" y="732"/>
                </a:lnTo>
                <a:lnTo>
                  <a:pt x="911" y="738"/>
                </a:lnTo>
                <a:lnTo>
                  <a:pt x="895" y="744"/>
                </a:lnTo>
                <a:lnTo>
                  <a:pt x="878" y="750"/>
                </a:lnTo>
                <a:lnTo>
                  <a:pt x="861" y="750"/>
                </a:lnTo>
                <a:lnTo>
                  <a:pt x="844" y="756"/>
                </a:lnTo>
                <a:lnTo>
                  <a:pt x="828" y="762"/>
                </a:lnTo>
                <a:lnTo>
                  <a:pt x="805" y="768"/>
                </a:lnTo>
                <a:lnTo>
                  <a:pt x="788" y="774"/>
                </a:lnTo>
                <a:lnTo>
                  <a:pt x="772" y="774"/>
                </a:lnTo>
                <a:lnTo>
                  <a:pt x="755" y="774"/>
                </a:lnTo>
                <a:lnTo>
                  <a:pt x="738" y="780"/>
                </a:lnTo>
                <a:lnTo>
                  <a:pt x="721" y="786"/>
                </a:lnTo>
                <a:lnTo>
                  <a:pt x="705" y="792"/>
                </a:lnTo>
                <a:lnTo>
                  <a:pt x="688" y="798"/>
                </a:lnTo>
                <a:lnTo>
                  <a:pt x="671" y="798"/>
                </a:lnTo>
                <a:lnTo>
                  <a:pt x="654" y="804"/>
                </a:lnTo>
                <a:lnTo>
                  <a:pt x="637" y="810"/>
                </a:lnTo>
                <a:lnTo>
                  <a:pt x="621" y="810"/>
                </a:lnTo>
                <a:lnTo>
                  <a:pt x="604" y="816"/>
                </a:lnTo>
                <a:lnTo>
                  <a:pt x="587" y="816"/>
                </a:lnTo>
                <a:lnTo>
                  <a:pt x="570" y="822"/>
                </a:lnTo>
                <a:lnTo>
                  <a:pt x="554" y="822"/>
                </a:lnTo>
                <a:lnTo>
                  <a:pt x="537" y="822"/>
                </a:lnTo>
                <a:lnTo>
                  <a:pt x="520" y="828"/>
                </a:lnTo>
                <a:lnTo>
                  <a:pt x="503" y="834"/>
                </a:lnTo>
                <a:lnTo>
                  <a:pt x="487" y="840"/>
                </a:lnTo>
                <a:lnTo>
                  <a:pt x="470" y="846"/>
                </a:lnTo>
                <a:lnTo>
                  <a:pt x="453" y="846"/>
                </a:lnTo>
                <a:lnTo>
                  <a:pt x="436" y="846"/>
                </a:lnTo>
                <a:lnTo>
                  <a:pt x="419" y="852"/>
                </a:lnTo>
                <a:lnTo>
                  <a:pt x="403" y="858"/>
                </a:lnTo>
                <a:lnTo>
                  <a:pt x="386" y="864"/>
                </a:lnTo>
                <a:lnTo>
                  <a:pt x="369" y="870"/>
                </a:lnTo>
                <a:lnTo>
                  <a:pt x="352" y="870"/>
                </a:lnTo>
                <a:lnTo>
                  <a:pt x="336" y="870"/>
                </a:lnTo>
                <a:lnTo>
                  <a:pt x="319" y="876"/>
                </a:lnTo>
                <a:lnTo>
                  <a:pt x="302" y="882"/>
                </a:lnTo>
                <a:lnTo>
                  <a:pt x="285" y="888"/>
                </a:lnTo>
                <a:lnTo>
                  <a:pt x="268" y="894"/>
                </a:lnTo>
                <a:lnTo>
                  <a:pt x="252" y="894"/>
                </a:lnTo>
                <a:lnTo>
                  <a:pt x="235" y="894"/>
                </a:lnTo>
                <a:lnTo>
                  <a:pt x="218" y="900"/>
                </a:lnTo>
                <a:lnTo>
                  <a:pt x="201" y="906"/>
                </a:lnTo>
                <a:lnTo>
                  <a:pt x="185" y="912"/>
                </a:lnTo>
                <a:lnTo>
                  <a:pt x="168" y="918"/>
                </a:lnTo>
                <a:lnTo>
                  <a:pt x="151" y="918"/>
                </a:lnTo>
                <a:lnTo>
                  <a:pt x="134" y="924"/>
                </a:lnTo>
                <a:lnTo>
                  <a:pt x="117" y="930"/>
                </a:lnTo>
                <a:lnTo>
                  <a:pt x="101" y="936"/>
                </a:lnTo>
                <a:lnTo>
                  <a:pt x="84" y="936"/>
                </a:lnTo>
                <a:lnTo>
                  <a:pt x="67" y="942"/>
                </a:lnTo>
                <a:lnTo>
                  <a:pt x="50" y="942"/>
                </a:lnTo>
                <a:lnTo>
                  <a:pt x="34" y="942"/>
                </a:lnTo>
                <a:lnTo>
                  <a:pt x="17" y="948"/>
                </a:lnTo>
                <a:lnTo>
                  <a:pt x="0" y="948"/>
                </a:lnTo>
              </a:path>
            </a:pathLst>
          </a:custGeom>
          <a:noFill/>
          <a:ln w="25400" cap="rnd" cmpd="sng">
            <a:solidFill>
              <a:schemeClr val="tx2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0514" name="Freeform 34"/>
          <p:cNvSpPr>
            <a:spLocks/>
          </p:cNvSpPr>
          <p:nvPr/>
        </p:nvSpPr>
        <p:spPr bwMode="auto">
          <a:xfrm>
            <a:off x="4038600" y="5318073"/>
            <a:ext cx="458788" cy="439738"/>
          </a:xfrm>
          <a:custGeom>
            <a:avLst/>
            <a:gdLst>
              <a:gd name="T0" fmla="*/ 294 w 295"/>
              <a:gd name="T1" fmla="*/ 0 h 288"/>
              <a:gd name="T2" fmla="*/ 289 w 295"/>
              <a:gd name="T3" fmla="*/ 31 h 288"/>
              <a:gd name="T4" fmla="*/ 284 w 295"/>
              <a:gd name="T5" fmla="*/ 62 h 288"/>
              <a:gd name="T6" fmla="*/ 269 w 295"/>
              <a:gd name="T7" fmla="*/ 72 h 288"/>
              <a:gd name="T8" fmla="*/ 264 w 295"/>
              <a:gd name="T9" fmla="*/ 103 h 288"/>
              <a:gd name="T10" fmla="*/ 249 w 295"/>
              <a:gd name="T11" fmla="*/ 113 h 288"/>
              <a:gd name="T12" fmla="*/ 234 w 295"/>
              <a:gd name="T13" fmla="*/ 123 h 288"/>
              <a:gd name="T14" fmla="*/ 224 w 295"/>
              <a:gd name="T15" fmla="*/ 154 h 288"/>
              <a:gd name="T16" fmla="*/ 209 w 295"/>
              <a:gd name="T17" fmla="*/ 154 h 288"/>
              <a:gd name="T18" fmla="*/ 194 w 295"/>
              <a:gd name="T19" fmla="*/ 164 h 288"/>
              <a:gd name="T20" fmla="*/ 179 w 295"/>
              <a:gd name="T21" fmla="*/ 174 h 288"/>
              <a:gd name="T22" fmla="*/ 164 w 295"/>
              <a:gd name="T23" fmla="*/ 195 h 288"/>
              <a:gd name="T24" fmla="*/ 149 w 295"/>
              <a:gd name="T25" fmla="*/ 195 h 288"/>
              <a:gd name="T26" fmla="*/ 135 w 295"/>
              <a:gd name="T27" fmla="*/ 205 h 288"/>
              <a:gd name="T28" fmla="*/ 120 w 295"/>
              <a:gd name="T29" fmla="*/ 215 h 288"/>
              <a:gd name="T30" fmla="*/ 105 w 295"/>
              <a:gd name="T31" fmla="*/ 226 h 288"/>
              <a:gd name="T32" fmla="*/ 90 w 295"/>
              <a:gd name="T33" fmla="*/ 236 h 288"/>
              <a:gd name="T34" fmla="*/ 75 w 295"/>
              <a:gd name="T35" fmla="*/ 246 h 288"/>
              <a:gd name="T36" fmla="*/ 60 w 295"/>
              <a:gd name="T37" fmla="*/ 256 h 288"/>
              <a:gd name="T38" fmla="*/ 45 w 295"/>
              <a:gd name="T39" fmla="*/ 267 h 288"/>
              <a:gd name="T40" fmla="*/ 30 w 295"/>
              <a:gd name="T41" fmla="*/ 277 h 288"/>
              <a:gd name="T42" fmla="*/ 15 w 295"/>
              <a:gd name="T43" fmla="*/ 277 h 288"/>
              <a:gd name="T44" fmla="*/ 0 w 295"/>
              <a:gd name="T45" fmla="*/ 287 h 2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</a:cxnLst>
            <a:rect l="0" t="0" r="r" b="b"/>
            <a:pathLst>
              <a:path w="295" h="288">
                <a:moveTo>
                  <a:pt x="294" y="0"/>
                </a:moveTo>
                <a:lnTo>
                  <a:pt x="289" y="31"/>
                </a:lnTo>
                <a:lnTo>
                  <a:pt x="284" y="62"/>
                </a:lnTo>
                <a:lnTo>
                  <a:pt x="269" y="72"/>
                </a:lnTo>
                <a:lnTo>
                  <a:pt x="264" y="103"/>
                </a:lnTo>
                <a:lnTo>
                  <a:pt x="249" y="113"/>
                </a:lnTo>
                <a:lnTo>
                  <a:pt x="234" y="123"/>
                </a:lnTo>
                <a:lnTo>
                  <a:pt x="224" y="154"/>
                </a:lnTo>
                <a:lnTo>
                  <a:pt x="209" y="154"/>
                </a:lnTo>
                <a:lnTo>
                  <a:pt x="194" y="164"/>
                </a:lnTo>
                <a:lnTo>
                  <a:pt x="179" y="174"/>
                </a:lnTo>
                <a:lnTo>
                  <a:pt x="164" y="195"/>
                </a:lnTo>
                <a:lnTo>
                  <a:pt x="149" y="195"/>
                </a:lnTo>
                <a:lnTo>
                  <a:pt x="135" y="205"/>
                </a:lnTo>
                <a:lnTo>
                  <a:pt x="120" y="215"/>
                </a:lnTo>
                <a:lnTo>
                  <a:pt x="105" y="226"/>
                </a:lnTo>
                <a:lnTo>
                  <a:pt x="90" y="236"/>
                </a:lnTo>
                <a:lnTo>
                  <a:pt x="75" y="246"/>
                </a:lnTo>
                <a:lnTo>
                  <a:pt x="60" y="256"/>
                </a:lnTo>
                <a:lnTo>
                  <a:pt x="45" y="267"/>
                </a:lnTo>
                <a:lnTo>
                  <a:pt x="30" y="277"/>
                </a:lnTo>
                <a:lnTo>
                  <a:pt x="15" y="277"/>
                </a:lnTo>
                <a:lnTo>
                  <a:pt x="0" y="287"/>
                </a:lnTo>
              </a:path>
            </a:pathLst>
          </a:custGeom>
          <a:noFill/>
          <a:ln w="25400" cap="rnd" cmpd="sng">
            <a:solidFill>
              <a:schemeClr val="tx2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0515" name="Freeform 35"/>
          <p:cNvSpPr>
            <a:spLocks/>
          </p:cNvSpPr>
          <p:nvPr/>
        </p:nvSpPr>
        <p:spPr bwMode="auto">
          <a:xfrm>
            <a:off x="3495675" y="5689548"/>
            <a:ext cx="325438" cy="325438"/>
          </a:xfrm>
          <a:custGeom>
            <a:avLst/>
            <a:gdLst>
              <a:gd name="T0" fmla="*/ 208 w 209"/>
              <a:gd name="T1" fmla="*/ 0 h 213"/>
              <a:gd name="T2" fmla="*/ 208 w 209"/>
              <a:gd name="T3" fmla="*/ 19 h 213"/>
              <a:gd name="T4" fmla="*/ 202 w 209"/>
              <a:gd name="T5" fmla="*/ 37 h 213"/>
              <a:gd name="T6" fmla="*/ 196 w 209"/>
              <a:gd name="T7" fmla="*/ 56 h 213"/>
              <a:gd name="T8" fmla="*/ 177 w 209"/>
              <a:gd name="T9" fmla="*/ 69 h 213"/>
              <a:gd name="T10" fmla="*/ 159 w 209"/>
              <a:gd name="T11" fmla="*/ 81 h 213"/>
              <a:gd name="T12" fmla="*/ 147 w 209"/>
              <a:gd name="T13" fmla="*/ 100 h 213"/>
              <a:gd name="T14" fmla="*/ 128 w 209"/>
              <a:gd name="T15" fmla="*/ 106 h 213"/>
              <a:gd name="T16" fmla="*/ 122 w 209"/>
              <a:gd name="T17" fmla="*/ 125 h 213"/>
              <a:gd name="T18" fmla="*/ 104 w 209"/>
              <a:gd name="T19" fmla="*/ 131 h 213"/>
              <a:gd name="T20" fmla="*/ 98 w 209"/>
              <a:gd name="T21" fmla="*/ 150 h 213"/>
              <a:gd name="T22" fmla="*/ 80 w 209"/>
              <a:gd name="T23" fmla="*/ 150 h 213"/>
              <a:gd name="T24" fmla="*/ 73 w 209"/>
              <a:gd name="T25" fmla="*/ 168 h 213"/>
              <a:gd name="T26" fmla="*/ 55 w 209"/>
              <a:gd name="T27" fmla="*/ 175 h 213"/>
              <a:gd name="T28" fmla="*/ 37 w 209"/>
              <a:gd name="T29" fmla="*/ 187 h 213"/>
              <a:gd name="T30" fmla="*/ 18 w 209"/>
              <a:gd name="T31" fmla="*/ 200 h 213"/>
              <a:gd name="T32" fmla="*/ 0 w 209"/>
              <a:gd name="T33" fmla="*/ 212 h 2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09" h="213">
                <a:moveTo>
                  <a:pt x="208" y="0"/>
                </a:moveTo>
                <a:lnTo>
                  <a:pt x="208" y="19"/>
                </a:lnTo>
                <a:lnTo>
                  <a:pt x="202" y="37"/>
                </a:lnTo>
                <a:lnTo>
                  <a:pt x="196" y="56"/>
                </a:lnTo>
                <a:lnTo>
                  <a:pt x="177" y="69"/>
                </a:lnTo>
                <a:lnTo>
                  <a:pt x="159" y="81"/>
                </a:lnTo>
                <a:lnTo>
                  <a:pt x="147" y="100"/>
                </a:lnTo>
                <a:lnTo>
                  <a:pt x="128" y="106"/>
                </a:lnTo>
                <a:lnTo>
                  <a:pt x="122" y="125"/>
                </a:lnTo>
                <a:lnTo>
                  <a:pt x="104" y="131"/>
                </a:lnTo>
                <a:lnTo>
                  <a:pt x="98" y="150"/>
                </a:lnTo>
                <a:lnTo>
                  <a:pt x="80" y="150"/>
                </a:lnTo>
                <a:lnTo>
                  <a:pt x="73" y="168"/>
                </a:lnTo>
                <a:lnTo>
                  <a:pt x="55" y="175"/>
                </a:lnTo>
                <a:lnTo>
                  <a:pt x="37" y="187"/>
                </a:lnTo>
                <a:lnTo>
                  <a:pt x="18" y="200"/>
                </a:lnTo>
                <a:lnTo>
                  <a:pt x="0" y="212"/>
                </a:lnTo>
              </a:path>
            </a:pathLst>
          </a:custGeom>
          <a:noFill/>
          <a:ln w="25400" cap="rnd" cmpd="sng">
            <a:solidFill>
              <a:schemeClr val="tx2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0516" name="Line 36"/>
          <p:cNvSpPr>
            <a:spLocks noChangeShapeType="1"/>
          </p:cNvSpPr>
          <p:nvPr/>
        </p:nvSpPr>
        <p:spPr bwMode="auto">
          <a:xfrm>
            <a:off x="0" y="3921222"/>
            <a:ext cx="10528300" cy="6201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17" name="Rectangle 37"/>
          <p:cNvSpPr>
            <a:spLocks noChangeArrowheads="1"/>
          </p:cNvSpPr>
          <p:nvPr/>
        </p:nvSpPr>
        <p:spPr bwMode="auto">
          <a:xfrm>
            <a:off x="8830121" y="3642444"/>
            <a:ext cx="594229" cy="339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91041" tIns="46292" rIns="91041" bIns="46292">
            <a:spAutoFit/>
          </a:bodyPr>
          <a:lstStyle>
            <a:lvl1pPr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4025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08050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60488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12925" defTabSz="9080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701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273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1845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41725" defTabSz="90805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600" b="1" dirty="0"/>
              <a:t>skin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5297394" y="5847434"/>
            <a:ext cx="1718576" cy="588739"/>
            <a:chOff x="3921031" y="4039324"/>
            <a:chExt cx="1718576" cy="588739"/>
          </a:xfrm>
        </p:grpSpPr>
        <p:sp>
          <p:nvSpPr>
            <p:cNvPr id="20520" name="Rectangle 40"/>
            <p:cNvSpPr>
              <a:spLocks noChangeArrowheads="1"/>
            </p:cNvSpPr>
            <p:nvPr/>
          </p:nvSpPr>
          <p:spPr bwMode="auto">
            <a:xfrm>
              <a:off x="4412191" y="4103688"/>
              <a:ext cx="1227416" cy="524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91041" tIns="46292" rIns="91041" bIns="46292">
              <a:spAutoFit/>
            </a:bodyPr>
            <a:lstStyle>
              <a:lvl1pPr defTabSz="9080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4025" defTabSz="9080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08050" defTabSz="9080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60488" defTabSz="9080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12925" defTabSz="9080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70125" defTabSz="90805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27325" defTabSz="90805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184525" defTabSz="90805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41725" defTabSz="90805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0" hangingPunct="0"/>
              <a:r>
                <a:rPr lang="en-US" altLang="en-US" sz="1400" b="1" dirty="0">
                  <a:solidFill>
                    <a:srgbClr val="000000"/>
                  </a:solidFill>
                </a:rPr>
                <a:t>depolarized </a:t>
              </a:r>
            </a:p>
            <a:p>
              <a:pPr eaLnBrk="0" hangingPunct="0"/>
              <a:r>
                <a:rPr lang="en-US" altLang="en-US" sz="1400" b="1" dirty="0">
                  <a:solidFill>
                    <a:srgbClr val="000000"/>
                  </a:solidFill>
                </a:rPr>
                <a:t>zone</a:t>
              </a:r>
            </a:p>
          </p:txBody>
        </p:sp>
        <p:sp>
          <p:nvSpPr>
            <p:cNvPr id="20521" name="Line 41"/>
            <p:cNvSpPr>
              <a:spLocks noChangeShapeType="1"/>
            </p:cNvSpPr>
            <p:nvPr/>
          </p:nvSpPr>
          <p:spPr bwMode="auto">
            <a:xfrm flipH="1" flipV="1">
              <a:off x="3921031" y="4039324"/>
              <a:ext cx="528118" cy="422134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arrow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sp>
        <p:nvSpPr>
          <p:cNvPr id="20527" name="Line 47"/>
          <p:cNvSpPr>
            <a:spLocks noChangeShapeType="1"/>
          </p:cNvSpPr>
          <p:nvPr/>
        </p:nvSpPr>
        <p:spPr bwMode="auto">
          <a:xfrm>
            <a:off x="-1087821" y="3093986"/>
            <a:ext cx="11225981" cy="0"/>
          </a:xfrm>
          <a:prstGeom prst="line">
            <a:avLst/>
          </a:prstGeom>
          <a:noFill/>
          <a:ln w="12700">
            <a:solidFill>
              <a:srgbClr val="CE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87956" tIns="43206" rIns="87956" bIns="43206">
            <a:spAutoFit/>
          </a:bodyPr>
          <a:lstStyle/>
          <a:p>
            <a:endParaRPr lang="en-US"/>
          </a:p>
        </p:txBody>
      </p:sp>
      <p:sp>
        <p:nvSpPr>
          <p:cNvPr id="20530" name="Freeform 50"/>
          <p:cNvSpPr>
            <a:spLocks/>
          </p:cNvSpPr>
          <p:nvPr/>
        </p:nvSpPr>
        <p:spPr bwMode="auto">
          <a:xfrm>
            <a:off x="2328697" y="2964703"/>
            <a:ext cx="1481137" cy="364255"/>
          </a:xfrm>
          <a:custGeom>
            <a:avLst/>
            <a:gdLst>
              <a:gd name="T0" fmla="*/ 12 w 1226"/>
              <a:gd name="T1" fmla="*/ 108 h 470"/>
              <a:gd name="T2" fmla="*/ 37 w 1226"/>
              <a:gd name="T3" fmla="*/ 100 h 470"/>
              <a:gd name="T4" fmla="*/ 61 w 1226"/>
              <a:gd name="T5" fmla="*/ 87 h 470"/>
              <a:gd name="T6" fmla="*/ 82 w 1226"/>
              <a:gd name="T7" fmla="*/ 62 h 470"/>
              <a:gd name="T8" fmla="*/ 98 w 1226"/>
              <a:gd name="T9" fmla="*/ 37 h 470"/>
              <a:gd name="T10" fmla="*/ 118 w 1226"/>
              <a:gd name="T11" fmla="*/ 17 h 470"/>
              <a:gd name="T12" fmla="*/ 143 w 1226"/>
              <a:gd name="T13" fmla="*/ 4 h 470"/>
              <a:gd name="T14" fmla="*/ 167 w 1226"/>
              <a:gd name="T15" fmla="*/ 0 h 470"/>
              <a:gd name="T16" fmla="*/ 192 w 1226"/>
              <a:gd name="T17" fmla="*/ 0 h 470"/>
              <a:gd name="T18" fmla="*/ 216 w 1226"/>
              <a:gd name="T19" fmla="*/ 4 h 470"/>
              <a:gd name="T20" fmla="*/ 241 w 1226"/>
              <a:gd name="T21" fmla="*/ 21 h 470"/>
              <a:gd name="T22" fmla="*/ 265 w 1226"/>
              <a:gd name="T23" fmla="*/ 37 h 470"/>
              <a:gd name="T24" fmla="*/ 286 w 1226"/>
              <a:gd name="T25" fmla="*/ 58 h 470"/>
              <a:gd name="T26" fmla="*/ 302 w 1226"/>
              <a:gd name="T27" fmla="*/ 83 h 470"/>
              <a:gd name="T28" fmla="*/ 319 w 1226"/>
              <a:gd name="T29" fmla="*/ 108 h 470"/>
              <a:gd name="T30" fmla="*/ 339 w 1226"/>
              <a:gd name="T31" fmla="*/ 129 h 470"/>
              <a:gd name="T32" fmla="*/ 351 w 1226"/>
              <a:gd name="T33" fmla="*/ 154 h 470"/>
              <a:gd name="T34" fmla="*/ 368 w 1226"/>
              <a:gd name="T35" fmla="*/ 178 h 470"/>
              <a:gd name="T36" fmla="*/ 384 w 1226"/>
              <a:gd name="T37" fmla="*/ 203 h 470"/>
              <a:gd name="T38" fmla="*/ 392 w 1226"/>
              <a:gd name="T39" fmla="*/ 228 h 470"/>
              <a:gd name="T40" fmla="*/ 404 w 1226"/>
              <a:gd name="T41" fmla="*/ 253 h 470"/>
              <a:gd name="T42" fmla="*/ 412 w 1226"/>
              <a:gd name="T43" fmla="*/ 278 h 470"/>
              <a:gd name="T44" fmla="*/ 425 w 1226"/>
              <a:gd name="T45" fmla="*/ 303 h 470"/>
              <a:gd name="T46" fmla="*/ 441 w 1226"/>
              <a:gd name="T47" fmla="*/ 328 h 470"/>
              <a:gd name="T48" fmla="*/ 457 w 1226"/>
              <a:gd name="T49" fmla="*/ 353 h 470"/>
              <a:gd name="T50" fmla="*/ 474 w 1226"/>
              <a:gd name="T51" fmla="*/ 378 h 470"/>
              <a:gd name="T52" fmla="*/ 498 w 1226"/>
              <a:gd name="T53" fmla="*/ 403 h 470"/>
              <a:gd name="T54" fmla="*/ 519 w 1226"/>
              <a:gd name="T55" fmla="*/ 423 h 470"/>
              <a:gd name="T56" fmla="*/ 543 w 1226"/>
              <a:gd name="T57" fmla="*/ 448 h 470"/>
              <a:gd name="T58" fmla="*/ 568 w 1226"/>
              <a:gd name="T59" fmla="*/ 461 h 470"/>
              <a:gd name="T60" fmla="*/ 592 w 1226"/>
              <a:gd name="T61" fmla="*/ 469 h 470"/>
              <a:gd name="T62" fmla="*/ 617 w 1226"/>
              <a:gd name="T63" fmla="*/ 465 h 470"/>
              <a:gd name="T64" fmla="*/ 645 w 1226"/>
              <a:gd name="T65" fmla="*/ 457 h 470"/>
              <a:gd name="T66" fmla="*/ 670 w 1226"/>
              <a:gd name="T67" fmla="*/ 448 h 470"/>
              <a:gd name="T68" fmla="*/ 694 w 1226"/>
              <a:gd name="T69" fmla="*/ 432 h 470"/>
              <a:gd name="T70" fmla="*/ 715 w 1226"/>
              <a:gd name="T71" fmla="*/ 407 h 470"/>
              <a:gd name="T72" fmla="*/ 735 w 1226"/>
              <a:gd name="T73" fmla="*/ 378 h 470"/>
              <a:gd name="T74" fmla="*/ 760 w 1226"/>
              <a:gd name="T75" fmla="*/ 349 h 470"/>
              <a:gd name="T76" fmla="*/ 776 w 1226"/>
              <a:gd name="T77" fmla="*/ 324 h 470"/>
              <a:gd name="T78" fmla="*/ 792 w 1226"/>
              <a:gd name="T79" fmla="*/ 299 h 470"/>
              <a:gd name="T80" fmla="*/ 809 w 1226"/>
              <a:gd name="T81" fmla="*/ 274 h 470"/>
              <a:gd name="T82" fmla="*/ 821 w 1226"/>
              <a:gd name="T83" fmla="*/ 245 h 470"/>
              <a:gd name="T84" fmla="*/ 833 w 1226"/>
              <a:gd name="T85" fmla="*/ 216 h 470"/>
              <a:gd name="T86" fmla="*/ 845 w 1226"/>
              <a:gd name="T87" fmla="*/ 183 h 470"/>
              <a:gd name="T88" fmla="*/ 858 w 1226"/>
              <a:gd name="T89" fmla="*/ 158 h 470"/>
              <a:gd name="T90" fmla="*/ 870 w 1226"/>
              <a:gd name="T91" fmla="*/ 133 h 470"/>
              <a:gd name="T92" fmla="*/ 890 w 1226"/>
              <a:gd name="T93" fmla="*/ 108 h 470"/>
              <a:gd name="T94" fmla="*/ 907 w 1226"/>
              <a:gd name="T95" fmla="*/ 83 h 470"/>
              <a:gd name="T96" fmla="*/ 927 w 1226"/>
              <a:gd name="T97" fmla="*/ 54 h 470"/>
              <a:gd name="T98" fmla="*/ 947 w 1226"/>
              <a:gd name="T99" fmla="*/ 25 h 470"/>
              <a:gd name="T100" fmla="*/ 972 w 1226"/>
              <a:gd name="T101" fmla="*/ 12 h 470"/>
              <a:gd name="T102" fmla="*/ 1000 w 1226"/>
              <a:gd name="T103" fmla="*/ 12 h 470"/>
              <a:gd name="T104" fmla="*/ 1025 w 1226"/>
              <a:gd name="T105" fmla="*/ 21 h 470"/>
              <a:gd name="T106" fmla="*/ 1054 w 1226"/>
              <a:gd name="T107" fmla="*/ 33 h 470"/>
              <a:gd name="T108" fmla="*/ 1078 w 1226"/>
              <a:gd name="T109" fmla="*/ 50 h 470"/>
              <a:gd name="T110" fmla="*/ 1103 w 1226"/>
              <a:gd name="T111" fmla="*/ 62 h 470"/>
              <a:gd name="T112" fmla="*/ 1127 w 1226"/>
              <a:gd name="T113" fmla="*/ 79 h 470"/>
              <a:gd name="T114" fmla="*/ 1152 w 1226"/>
              <a:gd name="T115" fmla="*/ 91 h 470"/>
              <a:gd name="T116" fmla="*/ 1176 w 1226"/>
              <a:gd name="T117" fmla="*/ 104 h 470"/>
              <a:gd name="T118" fmla="*/ 1201 w 1226"/>
              <a:gd name="T119" fmla="*/ 116 h 470"/>
              <a:gd name="T120" fmla="*/ 1225 w 1226"/>
              <a:gd name="T121" fmla="*/ 120 h 4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1226" h="470">
                <a:moveTo>
                  <a:pt x="0" y="112"/>
                </a:moveTo>
                <a:lnTo>
                  <a:pt x="12" y="108"/>
                </a:lnTo>
                <a:lnTo>
                  <a:pt x="25" y="108"/>
                </a:lnTo>
                <a:lnTo>
                  <a:pt x="37" y="100"/>
                </a:lnTo>
                <a:lnTo>
                  <a:pt x="49" y="95"/>
                </a:lnTo>
                <a:lnTo>
                  <a:pt x="61" y="87"/>
                </a:lnTo>
                <a:lnTo>
                  <a:pt x="69" y="75"/>
                </a:lnTo>
                <a:lnTo>
                  <a:pt x="82" y="62"/>
                </a:lnTo>
                <a:lnTo>
                  <a:pt x="90" y="50"/>
                </a:lnTo>
                <a:lnTo>
                  <a:pt x="98" y="37"/>
                </a:lnTo>
                <a:lnTo>
                  <a:pt x="106" y="25"/>
                </a:lnTo>
                <a:lnTo>
                  <a:pt x="118" y="17"/>
                </a:lnTo>
                <a:lnTo>
                  <a:pt x="131" y="8"/>
                </a:lnTo>
                <a:lnTo>
                  <a:pt x="143" y="4"/>
                </a:lnTo>
                <a:lnTo>
                  <a:pt x="155" y="0"/>
                </a:lnTo>
                <a:lnTo>
                  <a:pt x="167" y="0"/>
                </a:lnTo>
                <a:lnTo>
                  <a:pt x="180" y="0"/>
                </a:lnTo>
                <a:lnTo>
                  <a:pt x="192" y="0"/>
                </a:lnTo>
                <a:lnTo>
                  <a:pt x="204" y="4"/>
                </a:lnTo>
                <a:lnTo>
                  <a:pt x="216" y="4"/>
                </a:lnTo>
                <a:lnTo>
                  <a:pt x="229" y="12"/>
                </a:lnTo>
                <a:lnTo>
                  <a:pt x="241" y="21"/>
                </a:lnTo>
                <a:lnTo>
                  <a:pt x="253" y="25"/>
                </a:lnTo>
                <a:lnTo>
                  <a:pt x="265" y="37"/>
                </a:lnTo>
                <a:lnTo>
                  <a:pt x="278" y="46"/>
                </a:lnTo>
                <a:lnTo>
                  <a:pt x="286" y="58"/>
                </a:lnTo>
                <a:lnTo>
                  <a:pt x="298" y="71"/>
                </a:lnTo>
                <a:lnTo>
                  <a:pt x="302" y="83"/>
                </a:lnTo>
                <a:lnTo>
                  <a:pt x="314" y="95"/>
                </a:lnTo>
                <a:lnTo>
                  <a:pt x="319" y="108"/>
                </a:lnTo>
                <a:lnTo>
                  <a:pt x="331" y="116"/>
                </a:lnTo>
                <a:lnTo>
                  <a:pt x="339" y="129"/>
                </a:lnTo>
                <a:lnTo>
                  <a:pt x="343" y="141"/>
                </a:lnTo>
                <a:lnTo>
                  <a:pt x="351" y="154"/>
                </a:lnTo>
                <a:lnTo>
                  <a:pt x="359" y="166"/>
                </a:lnTo>
                <a:lnTo>
                  <a:pt x="368" y="178"/>
                </a:lnTo>
                <a:lnTo>
                  <a:pt x="376" y="191"/>
                </a:lnTo>
                <a:lnTo>
                  <a:pt x="384" y="203"/>
                </a:lnTo>
                <a:lnTo>
                  <a:pt x="388" y="216"/>
                </a:lnTo>
                <a:lnTo>
                  <a:pt x="392" y="228"/>
                </a:lnTo>
                <a:lnTo>
                  <a:pt x="396" y="241"/>
                </a:lnTo>
                <a:lnTo>
                  <a:pt x="404" y="253"/>
                </a:lnTo>
                <a:lnTo>
                  <a:pt x="408" y="266"/>
                </a:lnTo>
                <a:lnTo>
                  <a:pt x="412" y="278"/>
                </a:lnTo>
                <a:lnTo>
                  <a:pt x="421" y="291"/>
                </a:lnTo>
                <a:lnTo>
                  <a:pt x="425" y="303"/>
                </a:lnTo>
                <a:lnTo>
                  <a:pt x="433" y="315"/>
                </a:lnTo>
                <a:lnTo>
                  <a:pt x="441" y="328"/>
                </a:lnTo>
                <a:lnTo>
                  <a:pt x="449" y="340"/>
                </a:lnTo>
                <a:lnTo>
                  <a:pt x="457" y="353"/>
                </a:lnTo>
                <a:lnTo>
                  <a:pt x="466" y="365"/>
                </a:lnTo>
                <a:lnTo>
                  <a:pt x="474" y="378"/>
                </a:lnTo>
                <a:lnTo>
                  <a:pt x="486" y="390"/>
                </a:lnTo>
                <a:lnTo>
                  <a:pt x="498" y="403"/>
                </a:lnTo>
                <a:lnTo>
                  <a:pt x="506" y="415"/>
                </a:lnTo>
                <a:lnTo>
                  <a:pt x="519" y="423"/>
                </a:lnTo>
                <a:lnTo>
                  <a:pt x="531" y="436"/>
                </a:lnTo>
                <a:lnTo>
                  <a:pt x="543" y="448"/>
                </a:lnTo>
                <a:lnTo>
                  <a:pt x="555" y="457"/>
                </a:lnTo>
                <a:lnTo>
                  <a:pt x="568" y="461"/>
                </a:lnTo>
                <a:lnTo>
                  <a:pt x="580" y="465"/>
                </a:lnTo>
                <a:lnTo>
                  <a:pt x="592" y="469"/>
                </a:lnTo>
                <a:lnTo>
                  <a:pt x="604" y="469"/>
                </a:lnTo>
                <a:lnTo>
                  <a:pt x="617" y="465"/>
                </a:lnTo>
                <a:lnTo>
                  <a:pt x="633" y="461"/>
                </a:lnTo>
                <a:lnTo>
                  <a:pt x="645" y="457"/>
                </a:lnTo>
                <a:lnTo>
                  <a:pt x="657" y="452"/>
                </a:lnTo>
                <a:lnTo>
                  <a:pt x="670" y="448"/>
                </a:lnTo>
                <a:lnTo>
                  <a:pt x="682" y="440"/>
                </a:lnTo>
                <a:lnTo>
                  <a:pt x="694" y="432"/>
                </a:lnTo>
                <a:lnTo>
                  <a:pt x="702" y="419"/>
                </a:lnTo>
                <a:lnTo>
                  <a:pt x="715" y="407"/>
                </a:lnTo>
                <a:lnTo>
                  <a:pt x="727" y="390"/>
                </a:lnTo>
                <a:lnTo>
                  <a:pt x="735" y="378"/>
                </a:lnTo>
                <a:lnTo>
                  <a:pt x="747" y="361"/>
                </a:lnTo>
                <a:lnTo>
                  <a:pt x="760" y="349"/>
                </a:lnTo>
                <a:lnTo>
                  <a:pt x="768" y="336"/>
                </a:lnTo>
                <a:lnTo>
                  <a:pt x="776" y="324"/>
                </a:lnTo>
                <a:lnTo>
                  <a:pt x="784" y="311"/>
                </a:lnTo>
                <a:lnTo>
                  <a:pt x="792" y="299"/>
                </a:lnTo>
                <a:lnTo>
                  <a:pt x="804" y="286"/>
                </a:lnTo>
                <a:lnTo>
                  <a:pt x="809" y="274"/>
                </a:lnTo>
                <a:lnTo>
                  <a:pt x="817" y="261"/>
                </a:lnTo>
                <a:lnTo>
                  <a:pt x="821" y="245"/>
                </a:lnTo>
                <a:lnTo>
                  <a:pt x="829" y="228"/>
                </a:lnTo>
                <a:lnTo>
                  <a:pt x="833" y="216"/>
                </a:lnTo>
                <a:lnTo>
                  <a:pt x="837" y="199"/>
                </a:lnTo>
                <a:lnTo>
                  <a:pt x="845" y="183"/>
                </a:lnTo>
                <a:lnTo>
                  <a:pt x="849" y="170"/>
                </a:lnTo>
                <a:lnTo>
                  <a:pt x="858" y="158"/>
                </a:lnTo>
                <a:lnTo>
                  <a:pt x="862" y="145"/>
                </a:lnTo>
                <a:lnTo>
                  <a:pt x="870" y="133"/>
                </a:lnTo>
                <a:lnTo>
                  <a:pt x="878" y="120"/>
                </a:lnTo>
                <a:lnTo>
                  <a:pt x="890" y="108"/>
                </a:lnTo>
                <a:lnTo>
                  <a:pt x="898" y="95"/>
                </a:lnTo>
                <a:lnTo>
                  <a:pt x="907" y="83"/>
                </a:lnTo>
                <a:lnTo>
                  <a:pt x="915" y="71"/>
                </a:lnTo>
                <a:lnTo>
                  <a:pt x="927" y="54"/>
                </a:lnTo>
                <a:lnTo>
                  <a:pt x="939" y="37"/>
                </a:lnTo>
                <a:lnTo>
                  <a:pt x="947" y="25"/>
                </a:lnTo>
                <a:lnTo>
                  <a:pt x="960" y="21"/>
                </a:lnTo>
                <a:lnTo>
                  <a:pt x="972" y="12"/>
                </a:lnTo>
                <a:lnTo>
                  <a:pt x="984" y="12"/>
                </a:lnTo>
                <a:lnTo>
                  <a:pt x="1000" y="12"/>
                </a:lnTo>
                <a:lnTo>
                  <a:pt x="1013" y="17"/>
                </a:lnTo>
                <a:lnTo>
                  <a:pt x="1025" y="21"/>
                </a:lnTo>
                <a:lnTo>
                  <a:pt x="1037" y="29"/>
                </a:lnTo>
                <a:lnTo>
                  <a:pt x="1054" y="33"/>
                </a:lnTo>
                <a:lnTo>
                  <a:pt x="1066" y="42"/>
                </a:lnTo>
                <a:lnTo>
                  <a:pt x="1078" y="50"/>
                </a:lnTo>
                <a:lnTo>
                  <a:pt x="1090" y="58"/>
                </a:lnTo>
                <a:lnTo>
                  <a:pt x="1103" y="62"/>
                </a:lnTo>
                <a:lnTo>
                  <a:pt x="1115" y="71"/>
                </a:lnTo>
                <a:lnTo>
                  <a:pt x="1127" y="79"/>
                </a:lnTo>
                <a:lnTo>
                  <a:pt x="1139" y="87"/>
                </a:lnTo>
                <a:lnTo>
                  <a:pt x="1152" y="91"/>
                </a:lnTo>
                <a:lnTo>
                  <a:pt x="1164" y="100"/>
                </a:lnTo>
                <a:lnTo>
                  <a:pt x="1176" y="104"/>
                </a:lnTo>
                <a:lnTo>
                  <a:pt x="1188" y="112"/>
                </a:lnTo>
                <a:lnTo>
                  <a:pt x="1201" y="116"/>
                </a:lnTo>
                <a:lnTo>
                  <a:pt x="1213" y="116"/>
                </a:lnTo>
                <a:lnTo>
                  <a:pt x="1225" y="120"/>
                </a:lnTo>
              </a:path>
            </a:pathLst>
          </a:custGeom>
          <a:noFill/>
          <a:ln w="28575" cap="rnd" cmpd="sng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7956" tIns="43206" rIns="87956" bIns="43206">
            <a:spAutoFit/>
          </a:bodyPr>
          <a:lstStyle/>
          <a:p>
            <a:endParaRPr lang="en-US"/>
          </a:p>
        </p:txBody>
      </p:sp>
      <p:sp>
        <p:nvSpPr>
          <p:cNvPr id="20532" name="Rectangle 52"/>
          <p:cNvSpPr>
            <a:spLocks noChangeArrowheads="1"/>
          </p:cNvSpPr>
          <p:nvPr/>
        </p:nvSpPr>
        <p:spPr bwMode="auto">
          <a:xfrm>
            <a:off x="9087355" y="3060898"/>
            <a:ext cx="882951" cy="3026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CE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87956" tIns="43206" rIns="87956" bIns="43206">
            <a:spAutoFit/>
          </a:bodyPr>
          <a:lstStyle>
            <a:lvl1pPr defTabSz="741363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555625" defTabSz="741363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11250" defTabSz="741363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66875" defTabSz="741363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222500" defTabSz="741363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679700" defTabSz="74136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3136900" defTabSz="74136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594100" defTabSz="74136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4051300" defTabSz="74136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 dirty="0"/>
              <a:t>x, space</a:t>
            </a:r>
          </a:p>
        </p:txBody>
      </p:sp>
      <p:sp>
        <p:nvSpPr>
          <p:cNvPr id="20538" name="Rectangle 58"/>
          <p:cNvSpPr>
            <a:spLocks noChangeArrowheads="1"/>
          </p:cNvSpPr>
          <p:nvPr/>
        </p:nvSpPr>
        <p:spPr bwMode="auto">
          <a:xfrm>
            <a:off x="9652000" y="5416498"/>
            <a:ext cx="2540000" cy="49530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39" name="Rectangle 59"/>
          <p:cNvSpPr>
            <a:spLocks noChangeArrowheads="1"/>
          </p:cNvSpPr>
          <p:nvPr/>
        </p:nvSpPr>
        <p:spPr bwMode="auto">
          <a:xfrm>
            <a:off x="10390188" y="5056136"/>
            <a:ext cx="1870076" cy="360362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40" name="Rectangle 60"/>
          <p:cNvSpPr>
            <a:spLocks noChangeArrowheads="1"/>
          </p:cNvSpPr>
          <p:nvPr/>
        </p:nvSpPr>
        <p:spPr bwMode="auto">
          <a:xfrm>
            <a:off x="10092483" y="4695087"/>
            <a:ext cx="2071686" cy="404812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62" name="Text Box 82"/>
          <p:cNvSpPr txBox="1">
            <a:spLocks noChangeArrowheads="1"/>
          </p:cNvSpPr>
          <p:nvPr/>
        </p:nvSpPr>
        <p:spPr bwMode="auto">
          <a:xfrm rot="-731685">
            <a:off x="1810683" y="6226159"/>
            <a:ext cx="1415772" cy="3539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0" hangingPunct="0"/>
            <a:r>
              <a:rPr lang="en-US" altLang="en-US" sz="1700" b="1" dirty="0">
                <a:sym typeface="Symbol" panose="05050102010706020507" pitchFamily="18" charset="2"/>
              </a:rPr>
              <a:t> </a:t>
            </a:r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motoneuron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Down Arrow 1"/>
          <p:cNvSpPr/>
          <p:nvPr/>
        </p:nvSpPr>
        <p:spPr>
          <a:xfrm>
            <a:off x="7346613" y="3312416"/>
            <a:ext cx="85061" cy="56435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7367875" y="3202492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flipH="1">
            <a:off x="7362190" y="242773"/>
            <a:ext cx="890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it-IT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(t)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41" name="Rectangle 61"/>
          <p:cNvSpPr>
            <a:spLocks noChangeArrowheads="1"/>
          </p:cNvSpPr>
          <p:nvPr/>
        </p:nvSpPr>
        <p:spPr bwMode="auto">
          <a:xfrm>
            <a:off x="7334252" y="208520"/>
            <a:ext cx="3055937" cy="1322774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0531" name="Freeform 51"/>
          <p:cNvSpPr>
            <a:spLocks/>
          </p:cNvSpPr>
          <p:nvPr/>
        </p:nvSpPr>
        <p:spPr bwMode="auto">
          <a:xfrm>
            <a:off x="4598734" y="2977229"/>
            <a:ext cx="1558925" cy="364255"/>
          </a:xfrm>
          <a:custGeom>
            <a:avLst/>
            <a:gdLst>
              <a:gd name="T0" fmla="*/ 12 w 1226"/>
              <a:gd name="T1" fmla="*/ 108 h 470"/>
              <a:gd name="T2" fmla="*/ 37 w 1226"/>
              <a:gd name="T3" fmla="*/ 100 h 470"/>
              <a:gd name="T4" fmla="*/ 61 w 1226"/>
              <a:gd name="T5" fmla="*/ 87 h 470"/>
              <a:gd name="T6" fmla="*/ 82 w 1226"/>
              <a:gd name="T7" fmla="*/ 62 h 470"/>
              <a:gd name="T8" fmla="*/ 98 w 1226"/>
              <a:gd name="T9" fmla="*/ 37 h 470"/>
              <a:gd name="T10" fmla="*/ 118 w 1226"/>
              <a:gd name="T11" fmla="*/ 17 h 470"/>
              <a:gd name="T12" fmla="*/ 143 w 1226"/>
              <a:gd name="T13" fmla="*/ 4 h 470"/>
              <a:gd name="T14" fmla="*/ 167 w 1226"/>
              <a:gd name="T15" fmla="*/ 0 h 470"/>
              <a:gd name="T16" fmla="*/ 192 w 1226"/>
              <a:gd name="T17" fmla="*/ 0 h 470"/>
              <a:gd name="T18" fmla="*/ 216 w 1226"/>
              <a:gd name="T19" fmla="*/ 4 h 470"/>
              <a:gd name="T20" fmla="*/ 241 w 1226"/>
              <a:gd name="T21" fmla="*/ 21 h 470"/>
              <a:gd name="T22" fmla="*/ 265 w 1226"/>
              <a:gd name="T23" fmla="*/ 37 h 470"/>
              <a:gd name="T24" fmla="*/ 286 w 1226"/>
              <a:gd name="T25" fmla="*/ 58 h 470"/>
              <a:gd name="T26" fmla="*/ 302 w 1226"/>
              <a:gd name="T27" fmla="*/ 83 h 470"/>
              <a:gd name="T28" fmla="*/ 319 w 1226"/>
              <a:gd name="T29" fmla="*/ 108 h 470"/>
              <a:gd name="T30" fmla="*/ 339 w 1226"/>
              <a:gd name="T31" fmla="*/ 129 h 470"/>
              <a:gd name="T32" fmla="*/ 351 w 1226"/>
              <a:gd name="T33" fmla="*/ 154 h 470"/>
              <a:gd name="T34" fmla="*/ 368 w 1226"/>
              <a:gd name="T35" fmla="*/ 178 h 470"/>
              <a:gd name="T36" fmla="*/ 384 w 1226"/>
              <a:gd name="T37" fmla="*/ 203 h 470"/>
              <a:gd name="T38" fmla="*/ 392 w 1226"/>
              <a:gd name="T39" fmla="*/ 228 h 470"/>
              <a:gd name="T40" fmla="*/ 404 w 1226"/>
              <a:gd name="T41" fmla="*/ 253 h 470"/>
              <a:gd name="T42" fmla="*/ 412 w 1226"/>
              <a:gd name="T43" fmla="*/ 278 h 470"/>
              <a:gd name="T44" fmla="*/ 425 w 1226"/>
              <a:gd name="T45" fmla="*/ 303 h 470"/>
              <a:gd name="T46" fmla="*/ 441 w 1226"/>
              <a:gd name="T47" fmla="*/ 328 h 470"/>
              <a:gd name="T48" fmla="*/ 457 w 1226"/>
              <a:gd name="T49" fmla="*/ 353 h 470"/>
              <a:gd name="T50" fmla="*/ 474 w 1226"/>
              <a:gd name="T51" fmla="*/ 378 h 470"/>
              <a:gd name="T52" fmla="*/ 498 w 1226"/>
              <a:gd name="T53" fmla="*/ 403 h 470"/>
              <a:gd name="T54" fmla="*/ 519 w 1226"/>
              <a:gd name="T55" fmla="*/ 423 h 470"/>
              <a:gd name="T56" fmla="*/ 543 w 1226"/>
              <a:gd name="T57" fmla="*/ 448 h 470"/>
              <a:gd name="T58" fmla="*/ 568 w 1226"/>
              <a:gd name="T59" fmla="*/ 461 h 470"/>
              <a:gd name="T60" fmla="*/ 592 w 1226"/>
              <a:gd name="T61" fmla="*/ 469 h 470"/>
              <a:gd name="T62" fmla="*/ 617 w 1226"/>
              <a:gd name="T63" fmla="*/ 465 h 470"/>
              <a:gd name="T64" fmla="*/ 645 w 1226"/>
              <a:gd name="T65" fmla="*/ 457 h 470"/>
              <a:gd name="T66" fmla="*/ 670 w 1226"/>
              <a:gd name="T67" fmla="*/ 448 h 470"/>
              <a:gd name="T68" fmla="*/ 694 w 1226"/>
              <a:gd name="T69" fmla="*/ 432 h 470"/>
              <a:gd name="T70" fmla="*/ 715 w 1226"/>
              <a:gd name="T71" fmla="*/ 407 h 470"/>
              <a:gd name="T72" fmla="*/ 735 w 1226"/>
              <a:gd name="T73" fmla="*/ 378 h 470"/>
              <a:gd name="T74" fmla="*/ 760 w 1226"/>
              <a:gd name="T75" fmla="*/ 349 h 470"/>
              <a:gd name="T76" fmla="*/ 776 w 1226"/>
              <a:gd name="T77" fmla="*/ 324 h 470"/>
              <a:gd name="T78" fmla="*/ 792 w 1226"/>
              <a:gd name="T79" fmla="*/ 299 h 470"/>
              <a:gd name="T80" fmla="*/ 809 w 1226"/>
              <a:gd name="T81" fmla="*/ 274 h 470"/>
              <a:gd name="T82" fmla="*/ 821 w 1226"/>
              <a:gd name="T83" fmla="*/ 245 h 470"/>
              <a:gd name="T84" fmla="*/ 833 w 1226"/>
              <a:gd name="T85" fmla="*/ 216 h 470"/>
              <a:gd name="T86" fmla="*/ 845 w 1226"/>
              <a:gd name="T87" fmla="*/ 183 h 470"/>
              <a:gd name="T88" fmla="*/ 858 w 1226"/>
              <a:gd name="T89" fmla="*/ 158 h 470"/>
              <a:gd name="T90" fmla="*/ 870 w 1226"/>
              <a:gd name="T91" fmla="*/ 133 h 470"/>
              <a:gd name="T92" fmla="*/ 890 w 1226"/>
              <a:gd name="T93" fmla="*/ 108 h 470"/>
              <a:gd name="T94" fmla="*/ 907 w 1226"/>
              <a:gd name="T95" fmla="*/ 83 h 470"/>
              <a:gd name="T96" fmla="*/ 927 w 1226"/>
              <a:gd name="T97" fmla="*/ 54 h 470"/>
              <a:gd name="T98" fmla="*/ 947 w 1226"/>
              <a:gd name="T99" fmla="*/ 25 h 470"/>
              <a:gd name="T100" fmla="*/ 972 w 1226"/>
              <a:gd name="T101" fmla="*/ 12 h 470"/>
              <a:gd name="T102" fmla="*/ 1000 w 1226"/>
              <a:gd name="T103" fmla="*/ 12 h 470"/>
              <a:gd name="T104" fmla="*/ 1025 w 1226"/>
              <a:gd name="T105" fmla="*/ 21 h 470"/>
              <a:gd name="T106" fmla="*/ 1054 w 1226"/>
              <a:gd name="T107" fmla="*/ 33 h 470"/>
              <a:gd name="T108" fmla="*/ 1078 w 1226"/>
              <a:gd name="T109" fmla="*/ 50 h 470"/>
              <a:gd name="T110" fmla="*/ 1103 w 1226"/>
              <a:gd name="T111" fmla="*/ 62 h 470"/>
              <a:gd name="T112" fmla="*/ 1127 w 1226"/>
              <a:gd name="T113" fmla="*/ 79 h 470"/>
              <a:gd name="T114" fmla="*/ 1152 w 1226"/>
              <a:gd name="T115" fmla="*/ 91 h 470"/>
              <a:gd name="T116" fmla="*/ 1176 w 1226"/>
              <a:gd name="T117" fmla="*/ 104 h 470"/>
              <a:gd name="T118" fmla="*/ 1201 w 1226"/>
              <a:gd name="T119" fmla="*/ 116 h 470"/>
              <a:gd name="T120" fmla="*/ 1225 w 1226"/>
              <a:gd name="T121" fmla="*/ 120 h 4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1226" h="470">
                <a:moveTo>
                  <a:pt x="0" y="112"/>
                </a:moveTo>
                <a:lnTo>
                  <a:pt x="12" y="108"/>
                </a:lnTo>
                <a:lnTo>
                  <a:pt x="25" y="108"/>
                </a:lnTo>
                <a:lnTo>
                  <a:pt x="37" y="100"/>
                </a:lnTo>
                <a:lnTo>
                  <a:pt x="49" y="95"/>
                </a:lnTo>
                <a:lnTo>
                  <a:pt x="61" y="87"/>
                </a:lnTo>
                <a:lnTo>
                  <a:pt x="69" y="75"/>
                </a:lnTo>
                <a:lnTo>
                  <a:pt x="82" y="62"/>
                </a:lnTo>
                <a:lnTo>
                  <a:pt x="90" y="50"/>
                </a:lnTo>
                <a:lnTo>
                  <a:pt x="98" y="37"/>
                </a:lnTo>
                <a:lnTo>
                  <a:pt x="106" y="25"/>
                </a:lnTo>
                <a:lnTo>
                  <a:pt x="118" y="17"/>
                </a:lnTo>
                <a:lnTo>
                  <a:pt x="131" y="8"/>
                </a:lnTo>
                <a:lnTo>
                  <a:pt x="143" y="4"/>
                </a:lnTo>
                <a:lnTo>
                  <a:pt x="155" y="0"/>
                </a:lnTo>
                <a:lnTo>
                  <a:pt x="167" y="0"/>
                </a:lnTo>
                <a:lnTo>
                  <a:pt x="180" y="0"/>
                </a:lnTo>
                <a:lnTo>
                  <a:pt x="192" y="0"/>
                </a:lnTo>
                <a:lnTo>
                  <a:pt x="204" y="4"/>
                </a:lnTo>
                <a:lnTo>
                  <a:pt x="216" y="4"/>
                </a:lnTo>
                <a:lnTo>
                  <a:pt x="229" y="12"/>
                </a:lnTo>
                <a:lnTo>
                  <a:pt x="241" y="21"/>
                </a:lnTo>
                <a:lnTo>
                  <a:pt x="253" y="25"/>
                </a:lnTo>
                <a:lnTo>
                  <a:pt x="265" y="37"/>
                </a:lnTo>
                <a:lnTo>
                  <a:pt x="278" y="46"/>
                </a:lnTo>
                <a:lnTo>
                  <a:pt x="286" y="58"/>
                </a:lnTo>
                <a:lnTo>
                  <a:pt x="298" y="71"/>
                </a:lnTo>
                <a:lnTo>
                  <a:pt x="302" y="83"/>
                </a:lnTo>
                <a:lnTo>
                  <a:pt x="314" y="95"/>
                </a:lnTo>
                <a:lnTo>
                  <a:pt x="319" y="108"/>
                </a:lnTo>
                <a:lnTo>
                  <a:pt x="331" y="116"/>
                </a:lnTo>
                <a:lnTo>
                  <a:pt x="339" y="129"/>
                </a:lnTo>
                <a:lnTo>
                  <a:pt x="343" y="141"/>
                </a:lnTo>
                <a:lnTo>
                  <a:pt x="351" y="154"/>
                </a:lnTo>
                <a:lnTo>
                  <a:pt x="359" y="166"/>
                </a:lnTo>
                <a:lnTo>
                  <a:pt x="368" y="178"/>
                </a:lnTo>
                <a:lnTo>
                  <a:pt x="376" y="191"/>
                </a:lnTo>
                <a:lnTo>
                  <a:pt x="384" y="203"/>
                </a:lnTo>
                <a:lnTo>
                  <a:pt x="388" y="216"/>
                </a:lnTo>
                <a:lnTo>
                  <a:pt x="392" y="228"/>
                </a:lnTo>
                <a:lnTo>
                  <a:pt x="396" y="241"/>
                </a:lnTo>
                <a:lnTo>
                  <a:pt x="404" y="253"/>
                </a:lnTo>
                <a:lnTo>
                  <a:pt x="408" y="266"/>
                </a:lnTo>
                <a:lnTo>
                  <a:pt x="412" y="278"/>
                </a:lnTo>
                <a:lnTo>
                  <a:pt x="421" y="291"/>
                </a:lnTo>
                <a:lnTo>
                  <a:pt x="425" y="303"/>
                </a:lnTo>
                <a:lnTo>
                  <a:pt x="433" y="315"/>
                </a:lnTo>
                <a:lnTo>
                  <a:pt x="441" y="328"/>
                </a:lnTo>
                <a:lnTo>
                  <a:pt x="449" y="340"/>
                </a:lnTo>
                <a:lnTo>
                  <a:pt x="457" y="353"/>
                </a:lnTo>
                <a:lnTo>
                  <a:pt x="466" y="365"/>
                </a:lnTo>
                <a:lnTo>
                  <a:pt x="474" y="378"/>
                </a:lnTo>
                <a:lnTo>
                  <a:pt x="486" y="390"/>
                </a:lnTo>
                <a:lnTo>
                  <a:pt x="498" y="403"/>
                </a:lnTo>
                <a:lnTo>
                  <a:pt x="506" y="415"/>
                </a:lnTo>
                <a:lnTo>
                  <a:pt x="519" y="423"/>
                </a:lnTo>
                <a:lnTo>
                  <a:pt x="531" y="436"/>
                </a:lnTo>
                <a:lnTo>
                  <a:pt x="543" y="448"/>
                </a:lnTo>
                <a:lnTo>
                  <a:pt x="555" y="457"/>
                </a:lnTo>
                <a:lnTo>
                  <a:pt x="568" y="461"/>
                </a:lnTo>
                <a:lnTo>
                  <a:pt x="580" y="465"/>
                </a:lnTo>
                <a:lnTo>
                  <a:pt x="592" y="469"/>
                </a:lnTo>
                <a:lnTo>
                  <a:pt x="604" y="469"/>
                </a:lnTo>
                <a:lnTo>
                  <a:pt x="617" y="465"/>
                </a:lnTo>
                <a:lnTo>
                  <a:pt x="633" y="461"/>
                </a:lnTo>
                <a:lnTo>
                  <a:pt x="645" y="457"/>
                </a:lnTo>
                <a:lnTo>
                  <a:pt x="657" y="452"/>
                </a:lnTo>
                <a:lnTo>
                  <a:pt x="670" y="448"/>
                </a:lnTo>
                <a:lnTo>
                  <a:pt x="682" y="440"/>
                </a:lnTo>
                <a:lnTo>
                  <a:pt x="694" y="432"/>
                </a:lnTo>
                <a:lnTo>
                  <a:pt x="702" y="419"/>
                </a:lnTo>
                <a:lnTo>
                  <a:pt x="715" y="407"/>
                </a:lnTo>
                <a:lnTo>
                  <a:pt x="727" y="390"/>
                </a:lnTo>
                <a:lnTo>
                  <a:pt x="735" y="378"/>
                </a:lnTo>
                <a:lnTo>
                  <a:pt x="747" y="361"/>
                </a:lnTo>
                <a:lnTo>
                  <a:pt x="760" y="349"/>
                </a:lnTo>
                <a:lnTo>
                  <a:pt x="768" y="336"/>
                </a:lnTo>
                <a:lnTo>
                  <a:pt x="776" y="324"/>
                </a:lnTo>
                <a:lnTo>
                  <a:pt x="784" y="311"/>
                </a:lnTo>
                <a:lnTo>
                  <a:pt x="792" y="299"/>
                </a:lnTo>
                <a:lnTo>
                  <a:pt x="804" y="286"/>
                </a:lnTo>
                <a:lnTo>
                  <a:pt x="809" y="274"/>
                </a:lnTo>
                <a:lnTo>
                  <a:pt x="817" y="261"/>
                </a:lnTo>
                <a:lnTo>
                  <a:pt x="821" y="245"/>
                </a:lnTo>
                <a:lnTo>
                  <a:pt x="829" y="228"/>
                </a:lnTo>
                <a:lnTo>
                  <a:pt x="833" y="216"/>
                </a:lnTo>
                <a:lnTo>
                  <a:pt x="837" y="199"/>
                </a:lnTo>
                <a:lnTo>
                  <a:pt x="845" y="183"/>
                </a:lnTo>
                <a:lnTo>
                  <a:pt x="849" y="170"/>
                </a:lnTo>
                <a:lnTo>
                  <a:pt x="858" y="158"/>
                </a:lnTo>
                <a:lnTo>
                  <a:pt x="862" y="145"/>
                </a:lnTo>
                <a:lnTo>
                  <a:pt x="870" y="133"/>
                </a:lnTo>
                <a:lnTo>
                  <a:pt x="878" y="120"/>
                </a:lnTo>
                <a:lnTo>
                  <a:pt x="890" y="108"/>
                </a:lnTo>
                <a:lnTo>
                  <a:pt x="898" y="95"/>
                </a:lnTo>
                <a:lnTo>
                  <a:pt x="907" y="83"/>
                </a:lnTo>
                <a:lnTo>
                  <a:pt x="915" y="71"/>
                </a:lnTo>
                <a:lnTo>
                  <a:pt x="927" y="54"/>
                </a:lnTo>
                <a:lnTo>
                  <a:pt x="939" y="37"/>
                </a:lnTo>
                <a:lnTo>
                  <a:pt x="947" y="25"/>
                </a:lnTo>
                <a:lnTo>
                  <a:pt x="960" y="21"/>
                </a:lnTo>
                <a:lnTo>
                  <a:pt x="972" y="12"/>
                </a:lnTo>
                <a:lnTo>
                  <a:pt x="984" y="12"/>
                </a:lnTo>
                <a:lnTo>
                  <a:pt x="1000" y="12"/>
                </a:lnTo>
                <a:lnTo>
                  <a:pt x="1013" y="17"/>
                </a:lnTo>
                <a:lnTo>
                  <a:pt x="1025" y="21"/>
                </a:lnTo>
                <a:lnTo>
                  <a:pt x="1037" y="29"/>
                </a:lnTo>
                <a:lnTo>
                  <a:pt x="1054" y="33"/>
                </a:lnTo>
                <a:lnTo>
                  <a:pt x="1066" y="42"/>
                </a:lnTo>
                <a:lnTo>
                  <a:pt x="1078" y="50"/>
                </a:lnTo>
                <a:lnTo>
                  <a:pt x="1090" y="58"/>
                </a:lnTo>
                <a:lnTo>
                  <a:pt x="1103" y="62"/>
                </a:lnTo>
                <a:lnTo>
                  <a:pt x="1115" y="71"/>
                </a:lnTo>
                <a:lnTo>
                  <a:pt x="1127" y="79"/>
                </a:lnTo>
                <a:lnTo>
                  <a:pt x="1139" y="87"/>
                </a:lnTo>
                <a:lnTo>
                  <a:pt x="1152" y="91"/>
                </a:lnTo>
                <a:lnTo>
                  <a:pt x="1164" y="100"/>
                </a:lnTo>
                <a:lnTo>
                  <a:pt x="1176" y="104"/>
                </a:lnTo>
                <a:lnTo>
                  <a:pt x="1188" y="112"/>
                </a:lnTo>
                <a:lnTo>
                  <a:pt x="1201" y="116"/>
                </a:lnTo>
                <a:lnTo>
                  <a:pt x="1213" y="116"/>
                </a:lnTo>
                <a:lnTo>
                  <a:pt x="1225" y="120"/>
                </a:lnTo>
              </a:path>
            </a:pathLst>
          </a:custGeom>
          <a:noFill/>
          <a:ln w="28575" cap="rnd" cmpd="sng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7956" tIns="43206" rIns="87956" bIns="43206">
            <a:spAutoFit/>
          </a:bodyPr>
          <a:lstStyle/>
          <a:p>
            <a:endParaRPr lang="en-US"/>
          </a:p>
        </p:txBody>
      </p:sp>
      <p:sp>
        <p:nvSpPr>
          <p:cNvPr id="74" name="Down Arrow 73"/>
          <p:cNvSpPr/>
          <p:nvPr/>
        </p:nvSpPr>
        <p:spPr>
          <a:xfrm>
            <a:off x="7820291" y="3304175"/>
            <a:ext cx="85061" cy="56435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TextBox 74"/>
          <p:cNvSpPr txBox="1"/>
          <p:nvPr/>
        </p:nvSpPr>
        <p:spPr>
          <a:xfrm>
            <a:off x="7841553" y="3202492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Down Arrow 75"/>
          <p:cNvSpPr/>
          <p:nvPr/>
        </p:nvSpPr>
        <p:spPr>
          <a:xfrm>
            <a:off x="8265139" y="3291821"/>
            <a:ext cx="85061" cy="56435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TextBox 76"/>
          <p:cNvSpPr txBox="1"/>
          <p:nvPr/>
        </p:nvSpPr>
        <p:spPr>
          <a:xfrm>
            <a:off x="8286401" y="3202492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9" name="Group 78"/>
          <p:cNvGrpSpPr/>
          <p:nvPr/>
        </p:nvGrpSpPr>
        <p:grpSpPr>
          <a:xfrm>
            <a:off x="7371458" y="157686"/>
            <a:ext cx="2505885" cy="740905"/>
            <a:chOff x="5948709" y="2042974"/>
            <a:chExt cx="2505885" cy="740905"/>
          </a:xfrm>
        </p:grpSpPr>
        <p:sp>
          <p:nvSpPr>
            <p:cNvPr id="80" name="Freeform 51"/>
            <p:cNvSpPr>
              <a:spLocks/>
            </p:cNvSpPr>
            <p:nvPr/>
          </p:nvSpPr>
          <p:spPr bwMode="auto">
            <a:xfrm>
              <a:off x="5975443" y="2235570"/>
              <a:ext cx="1141112" cy="364255"/>
            </a:xfrm>
            <a:custGeom>
              <a:avLst/>
              <a:gdLst>
                <a:gd name="T0" fmla="*/ 12 w 1226"/>
                <a:gd name="T1" fmla="*/ 108 h 470"/>
                <a:gd name="T2" fmla="*/ 37 w 1226"/>
                <a:gd name="T3" fmla="*/ 100 h 470"/>
                <a:gd name="T4" fmla="*/ 61 w 1226"/>
                <a:gd name="T5" fmla="*/ 87 h 470"/>
                <a:gd name="T6" fmla="*/ 82 w 1226"/>
                <a:gd name="T7" fmla="*/ 62 h 470"/>
                <a:gd name="T8" fmla="*/ 98 w 1226"/>
                <a:gd name="T9" fmla="*/ 37 h 470"/>
                <a:gd name="T10" fmla="*/ 118 w 1226"/>
                <a:gd name="T11" fmla="*/ 17 h 470"/>
                <a:gd name="T12" fmla="*/ 143 w 1226"/>
                <a:gd name="T13" fmla="*/ 4 h 470"/>
                <a:gd name="T14" fmla="*/ 167 w 1226"/>
                <a:gd name="T15" fmla="*/ 0 h 470"/>
                <a:gd name="T16" fmla="*/ 192 w 1226"/>
                <a:gd name="T17" fmla="*/ 0 h 470"/>
                <a:gd name="T18" fmla="*/ 216 w 1226"/>
                <a:gd name="T19" fmla="*/ 4 h 470"/>
                <a:gd name="T20" fmla="*/ 241 w 1226"/>
                <a:gd name="T21" fmla="*/ 21 h 470"/>
                <a:gd name="T22" fmla="*/ 265 w 1226"/>
                <a:gd name="T23" fmla="*/ 37 h 470"/>
                <a:gd name="T24" fmla="*/ 286 w 1226"/>
                <a:gd name="T25" fmla="*/ 58 h 470"/>
                <a:gd name="T26" fmla="*/ 302 w 1226"/>
                <a:gd name="T27" fmla="*/ 83 h 470"/>
                <a:gd name="T28" fmla="*/ 319 w 1226"/>
                <a:gd name="T29" fmla="*/ 108 h 470"/>
                <a:gd name="T30" fmla="*/ 339 w 1226"/>
                <a:gd name="T31" fmla="*/ 129 h 470"/>
                <a:gd name="T32" fmla="*/ 351 w 1226"/>
                <a:gd name="T33" fmla="*/ 154 h 470"/>
                <a:gd name="T34" fmla="*/ 368 w 1226"/>
                <a:gd name="T35" fmla="*/ 178 h 470"/>
                <a:gd name="T36" fmla="*/ 384 w 1226"/>
                <a:gd name="T37" fmla="*/ 203 h 470"/>
                <a:gd name="T38" fmla="*/ 392 w 1226"/>
                <a:gd name="T39" fmla="*/ 228 h 470"/>
                <a:gd name="T40" fmla="*/ 404 w 1226"/>
                <a:gd name="T41" fmla="*/ 253 h 470"/>
                <a:gd name="T42" fmla="*/ 412 w 1226"/>
                <a:gd name="T43" fmla="*/ 278 h 470"/>
                <a:gd name="T44" fmla="*/ 425 w 1226"/>
                <a:gd name="T45" fmla="*/ 303 h 470"/>
                <a:gd name="T46" fmla="*/ 441 w 1226"/>
                <a:gd name="T47" fmla="*/ 328 h 470"/>
                <a:gd name="T48" fmla="*/ 457 w 1226"/>
                <a:gd name="T49" fmla="*/ 353 h 470"/>
                <a:gd name="T50" fmla="*/ 474 w 1226"/>
                <a:gd name="T51" fmla="*/ 378 h 470"/>
                <a:gd name="T52" fmla="*/ 498 w 1226"/>
                <a:gd name="T53" fmla="*/ 403 h 470"/>
                <a:gd name="T54" fmla="*/ 519 w 1226"/>
                <a:gd name="T55" fmla="*/ 423 h 470"/>
                <a:gd name="T56" fmla="*/ 543 w 1226"/>
                <a:gd name="T57" fmla="*/ 448 h 470"/>
                <a:gd name="T58" fmla="*/ 568 w 1226"/>
                <a:gd name="T59" fmla="*/ 461 h 470"/>
                <a:gd name="T60" fmla="*/ 592 w 1226"/>
                <a:gd name="T61" fmla="*/ 469 h 470"/>
                <a:gd name="T62" fmla="*/ 617 w 1226"/>
                <a:gd name="T63" fmla="*/ 465 h 470"/>
                <a:gd name="T64" fmla="*/ 645 w 1226"/>
                <a:gd name="T65" fmla="*/ 457 h 470"/>
                <a:gd name="T66" fmla="*/ 670 w 1226"/>
                <a:gd name="T67" fmla="*/ 448 h 470"/>
                <a:gd name="T68" fmla="*/ 694 w 1226"/>
                <a:gd name="T69" fmla="*/ 432 h 470"/>
                <a:gd name="T70" fmla="*/ 715 w 1226"/>
                <a:gd name="T71" fmla="*/ 407 h 470"/>
                <a:gd name="T72" fmla="*/ 735 w 1226"/>
                <a:gd name="T73" fmla="*/ 378 h 470"/>
                <a:gd name="T74" fmla="*/ 760 w 1226"/>
                <a:gd name="T75" fmla="*/ 349 h 470"/>
                <a:gd name="T76" fmla="*/ 776 w 1226"/>
                <a:gd name="T77" fmla="*/ 324 h 470"/>
                <a:gd name="T78" fmla="*/ 792 w 1226"/>
                <a:gd name="T79" fmla="*/ 299 h 470"/>
                <a:gd name="T80" fmla="*/ 809 w 1226"/>
                <a:gd name="T81" fmla="*/ 274 h 470"/>
                <a:gd name="T82" fmla="*/ 821 w 1226"/>
                <a:gd name="T83" fmla="*/ 245 h 470"/>
                <a:gd name="T84" fmla="*/ 833 w 1226"/>
                <a:gd name="T85" fmla="*/ 216 h 470"/>
                <a:gd name="T86" fmla="*/ 845 w 1226"/>
                <a:gd name="T87" fmla="*/ 183 h 470"/>
                <a:gd name="T88" fmla="*/ 858 w 1226"/>
                <a:gd name="T89" fmla="*/ 158 h 470"/>
                <a:gd name="T90" fmla="*/ 870 w 1226"/>
                <a:gd name="T91" fmla="*/ 133 h 470"/>
                <a:gd name="T92" fmla="*/ 890 w 1226"/>
                <a:gd name="T93" fmla="*/ 108 h 470"/>
                <a:gd name="T94" fmla="*/ 907 w 1226"/>
                <a:gd name="T95" fmla="*/ 83 h 470"/>
                <a:gd name="T96" fmla="*/ 927 w 1226"/>
                <a:gd name="T97" fmla="*/ 54 h 470"/>
                <a:gd name="T98" fmla="*/ 947 w 1226"/>
                <a:gd name="T99" fmla="*/ 25 h 470"/>
                <a:gd name="T100" fmla="*/ 972 w 1226"/>
                <a:gd name="T101" fmla="*/ 12 h 470"/>
                <a:gd name="T102" fmla="*/ 1000 w 1226"/>
                <a:gd name="T103" fmla="*/ 12 h 470"/>
                <a:gd name="T104" fmla="*/ 1025 w 1226"/>
                <a:gd name="T105" fmla="*/ 21 h 470"/>
                <a:gd name="T106" fmla="*/ 1054 w 1226"/>
                <a:gd name="T107" fmla="*/ 33 h 470"/>
                <a:gd name="T108" fmla="*/ 1078 w 1226"/>
                <a:gd name="T109" fmla="*/ 50 h 470"/>
                <a:gd name="T110" fmla="*/ 1103 w 1226"/>
                <a:gd name="T111" fmla="*/ 62 h 470"/>
                <a:gd name="T112" fmla="*/ 1127 w 1226"/>
                <a:gd name="T113" fmla="*/ 79 h 470"/>
                <a:gd name="T114" fmla="*/ 1152 w 1226"/>
                <a:gd name="T115" fmla="*/ 91 h 470"/>
                <a:gd name="T116" fmla="*/ 1176 w 1226"/>
                <a:gd name="T117" fmla="*/ 104 h 470"/>
                <a:gd name="T118" fmla="*/ 1201 w 1226"/>
                <a:gd name="T119" fmla="*/ 116 h 470"/>
                <a:gd name="T120" fmla="*/ 1225 w 1226"/>
                <a:gd name="T121" fmla="*/ 120 h 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1226" h="470">
                  <a:moveTo>
                    <a:pt x="0" y="112"/>
                  </a:moveTo>
                  <a:lnTo>
                    <a:pt x="12" y="108"/>
                  </a:lnTo>
                  <a:lnTo>
                    <a:pt x="25" y="108"/>
                  </a:lnTo>
                  <a:lnTo>
                    <a:pt x="37" y="100"/>
                  </a:lnTo>
                  <a:lnTo>
                    <a:pt x="49" y="95"/>
                  </a:lnTo>
                  <a:lnTo>
                    <a:pt x="61" y="87"/>
                  </a:lnTo>
                  <a:lnTo>
                    <a:pt x="69" y="75"/>
                  </a:lnTo>
                  <a:lnTo>
                    <a:pt x="82" y="62"/>
                  </a:lnTo>
                  <a:lnTo>
                    <a:pt x="90" y="50"/>
                  </a:lnTo>
                  <a:lnTo>
                    <a:pt x="98" y="37"/>
                  </a:lnTo>
                  <a:lnTo>
                    <a:pt x="106" y="25"/>
                  </a:lnTo>
                  <a:lnTo>
                    <a:pt x="118" y="17"/>
                  </a:lnTo>
                  <a:lnTo>
                    <a:pt x="131" y="8"/>
                  </a:lnTo>
                  <a:lnTo>
                    <a:pt x="143" y="4"/>
                  </a:lnTo>
                  <a:lnTo>
                    <a:pt x="155" y="0"/>
                  </a:lnTo>
                  <a:lnTo>
                    <a:pt x="167" y="0"/>
                  </a:lnTo>
                  <a:lnTo>
                    <a:pt x="180" y="0"/>
                  </a:lnTo>
                  <a:lnTo>
                    <a:pt x="192" y="0"/>
                  </a:lnTo>
                  <a:lnTo>
                    <a:pt x="204" y="4"/>
                  </a:lnTo>
                  <a:lnTo>
                    <a:pt x="216" y="4"/>
                  </a:lnTo>
                  <a:lnTo>
                    <a:pt x="229" y="12"/>
                  </a:lnTo>
                  <a:lnTo>
                    <a:pt x="241" y="21"/>
                  </a:lnTo>
                  <a:lnTo>
                    <a:pt x="253" y="25"/>
                  </a:lnTo>
                  <a:lnTo>
                    <a:pt x="265" y="37"/>
                  </a:lnTo>
                  <a:lnTo>
                    <a:pt x="278" y="46"/>
                  </a:lnTo>
                  <a:lnTo>
                    <a:pt x="286" y="58"/>
                  </a:lnTo>
                  <a:lnTo>
                    <a:pt x="298" y="71"/>
                  </a:lnTo>
                  <a:lnTo>
                    <a:pt x="302" y="83"/>
                  </a:lnTo>
                  <a:lnTo>
                    <a:pt x="314" y="95"/>
                  </a:lnTo>
                  <a:lnTo>
                    <a:pt x="319" y="108"/>
                  </a:lnTo>
                  <a:lnTo>
                    <a:pt x="331" y="116"/>
                  </a:lnTo>
                  <a:lnTo>
                    <a:pt x="339" y="129"/>
                  </a:lnTo>
                  <a:lnTo>
                    <a:pt x="343" y="141"/>
                  </a:lnTo>
                  <a:lnTo>
                    <a:pt x="351" y="154"/>
                  </a:lnTo>
                  <a:lnTo>
                    <a:pt x="359" y="166"/>
                  </a:lnTo>
                  <a:lnTo>
                    <a:pt x="368" y="178"/>
                  </a:lnTo>
                  <a:lnTo>
                    <a:pt x="376" y="191"/>
                  </a:lnTo>
                  <a:lnTo>
                    <a:pt x="384" y="203"/>
                  </a:lnTo>
                  <a:lnTo>
                    <a:pt x="388" y="216"/>
                  </a:lnTo>
                  <a:lnTo>
                    <a:pt x="392" y="228"/>
                  </a:lnTo>
                  <a:lnTo>
                    <a:pt x="396" y="241"/>
                  </a:lnTo>
                  <a:lnTo>
                    <a:pt x="404" y="253"/>
                  </a:lnTo>
                  <a:lnTo>
                    <a:pt x="408" y="266"/>
                  </a:lnTo>
                  <a:lnTo>
                    <a:pt x="412" y="278"/>
                  </a:lnTo>
                  <a:lnTo>
                    <a:pt x="421" y="291"/>
                  </a:lnTo>
                  <a:lnTo>
                    <a:pt x="425" y="303"/>
                  </a:lnTo>
                  <a:lnTo>
                    <a:pt x="433" y="315"/>
                  </a:lnTo>
                  <a:lnTo>
                    <a:pt x="441" y="328"/>
                  </a:lnTo>
                  <a:lnTo>
                    <a:pt x="449" y="340"/>
                  </a:lnTo>
                  <a:lnTo>
                    <a:pt x="457" y="353"/>
                  </a:lnTo>
                  <a:lnTo>
                    <a:pt x="466" y="365"/>
                  </a:lnTo>
                  <a:lnTo>
                    <a:pt x="474" y="378"/>
                  </a:lnTo>
                  <a:lnTo>
                    <a:pt x="486" y="390"/>
                  </a:lnTo>
                  <a:lnTo>
                    <a:pt x="498" y="403"/>
                  </a:lnTo>
                  <a:lnTo>
                    <a:pt x="506" y="415"/>
                  </a:lnTo>
                  <a:lnTo>
                    <a:pt x="519" y="423"/>
                  </a:lnTo>
                  <a:lnTo>
                    <a:pt x="531" y="436"/>
                  </a:lnTo>
                  <a:lnTo>
                    <a:pt x="543" y="448"/>
                  </a:lnTo>
                  <a:lnTo>
                    <a:pt x="555" y="457"/>
                  </a:lnTo>
                  <a:lnTo>
                    <a:pt x="568" y="461"/>
                  </a:lnTo>
                  <a:lnTo>
                    <a:pt x="580" y="465"/>
                  </a:lnTo>
                  <a:lnTo>
                    <a:pt x="592" y="469"/>
                  </a:lnTo>
                  <a:lnTo>
                    <a:pt x="604" y="469"/>
                  </a:lnTo>
                  <a:lnTo>
                    <a:pt x="617" y="465"/>
                  </a:lnTo>
                  <a:lnTo>
                    <a:pt x="633" y="461"/>
                  </a:lnTo>
                  <a:lnTo>
                    <a:pt x="645" y="457"/>
                  </a:lnTo>
                  <a:lnTo>
                    <a:pt x="657" y="452"/>
                  </a:lnTo>
                  <a:lnTo>
                    <a:pt x="670" y="448"/>
                  </a:lnTo>
                  <a:lnTo>
                    <a:pt x="682" y="440"/>
                  </a:lnTo>
                  <a:lnTo>
                    <a:pt x="694" y="432"/>
                  </a:lnTo>
                  <a:lnTo>
                    <a:pt x="702" y="419"/>
                  </a:lnTo>
                  <a:lnTo>
                    <a:pt x="715" y="407"/>
                  </a:lnTo>
                  <a:lnTo>
                    <a:pt x="727" y="390"/>
                  </a:lnTo>
                  <a:lnTo>
                    <a:pt x="735" y="378"/>
                  </a:lnTo>
                  <a:lnTo>
                    <a:pt x="747" y="361"/>
                  </a:lnTo>
                  <a:lnTo>
                    <a:pt x="760" y="349"/>
                  </a:lnTo>
                  <a:lnTo>
                    <a:pt x="768" y="336"/>
                  </a:lnTo>
                  <a:lnTo>
                    <a:pt x="776" y="324"/>
                  </a:lnTo>
                  <a:lnTo>
                    <a:pt x="784" y="311"/>
                  </a:lnTo>
                  <a:lnTo>
                    <a:pt x="792" y="299"/>
                  </a:lnTo>
                  <a:lnTo>
                    <a:pt x="804" y="286"/>
                  </a:lnTo>
                  <a:lnTo>
                    <a:pt x="809" y="274"/>
                  </a:lnTo>
                  <a:lnTo>
                    <a:pt x="817" y="261"/>
                  </a:lnTo>
                  <a:lnTo>
                    <a:pt x="821" y="245"/>
                  </a:lnTo>
                  <a:lnTo>
                    <a:pt x="829" y="228"/>
                  </a:lnTo>
                  <a:lnTo>
                    <a:pt x="833" y="216"/>
                  </a:lnTo>
                  <a:lnTo>
                    <a:pt x="837" y="199"/>
                  </a:lnTo>
                  <a:lnTo>
                    <a:pt x="845" y="183"/>
                  </a:lnTo>
                  <a:lnTo>
                    <a:pt x="849" y="170"/>
                  </a:lnTo>
                  <a:lnTo>
                    <a:pt x="858" y="158"/>
                  </a:lnTo>
                  <a:lnTo>
                    <a:pt x="862" y="145"/>
                  </a:lnTo>
                  <a:lnTo>
                    <a:pt x="870" y="133"/>
                  </a:lnTo>
                  <a:lnTo>
                    <a:pt x="878" y="120"/>
                  </a:lnTo>
                  <a:lnTo>
                    <a:pt x="890" y="108"/>
                  </a:lnTo>
                  <a:lnTo>
                    <a:pt x="898" y="95"/>
                  </a:lnTo>
                  <a:lnTo>
                    <a:pt x="907" y="83"/>
                  </a:lnTo>
                  <a:lnTo>
                    <a:pt x="915" y="71"/>
                  </a:lnTo>
                  <a:lnTo>
                    <a:pt x="927" y="54"/>
                  </a:lnTo>
                  <a:lnTo>
                    <a:pt x="939" y="37"/>
                  </a:lnTo>
                  <a:lnTo>
                    <a:pt x="947" y="25"/>
                  </a:lnTo>
                  <a:lnTo>
                    <a:pt x="960" y="21"/>
                  </a:lnTo>
                  <a:lnTo>
                    <a:pt x="972" y="12"/>
                  </a:lnTo>
                  <a:lnTo>
                    <a:pt x="984" y="12"/>
                  </a:lnTo>
                  <a:lnTo>
                    <a:pt x="1000" y="12"/>
                  </a:lnTo>
                  <a:lnTo>
                    <a:pt x="1013" y="17"/>
                  </a:lnTo>
                  <a:lnTo>
                    <a:pt x="1025" y="21"/>
                  </a:lnTo>
                  <a:lnTo>
                    <a:pt x="1037" y="29"/>
                  </a:lnTo>
                  <a:lnTo>
                    <a:pt x="1054" y="33"/>
                  </a:lnTo>
                  <a:lnTo>
                    <a:pt x="1066" y="42"/>
                  </a:lnTo>
                  <a:lnTo>
                    <a:pt x="1078" y="50"/>
                  </a:lnTo>
                  <a:lnTo>
                    <a:pt x="1090" y="58"/>
                  </a:lnTo>
                  <a:lnTo>
                    <a:pt x="1103" y="62"/>
                  </a:lnTo>
                  <a:lnTo>
                    <a:pt x="1115" y="71"/>
                  </a:lnTo>
                  <a:lnTo>
                    <a:pt x="1127" y="79"/>
                  </a:lnTo>
                  <a:lnTo>
                    <a:pt x="1139" y="87"/>
                  </a:lnTo>
                  <a:lnTo>
                    <a:pt x="1152" y="91"/>
                  </a:lnTo>
                  <a:lnTo>
                    <a:pt x="1164" y="100"/>
                  </a:lnTo>
                  <a:lnTo>
                    <a:pt x="1176" y="104"/>
                  </a:lnTo>
                  <a:lnTo>
                    <a:pt x="1188" y="112"/>
                  </a:lnTo>
                  <a:lnTo>
                    <a:pt x="1201" y="116"/>
                  </a:lnTo>
                  <a:lnTo>
                    <a:pt x="1213" y="116"/>
                  </a:lnTo>
                  <a:lnTo>
                    <a:pt x="1225" y="120"/>
                  </a:lnTo>
                </a:path>
              </a:pathLst>
            </a:custGeom>
            <a:noFill/>
            <a:ln w="28575" cap="rnd" cmpd="sng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87956" tIns="43206" rIns="87956" bIns="43206">
              <a:spAutoFit/>
            </a:bodyPr>
            <a:lstStyle/>
            <a:p>
              <a:endParaRPr lang="en-US"/>
            </a:p>
          </p:txBody>
        </p:sp>
        <p:cxnSp>
          <p:nvCxnSpPr>
            <p:cNvPr id="81" name="Straight Arrow Connector 80"/>
            <p:cNvCxnSpPr/>
            <p:nvPr/>
          </p:nvCxnSpPr>
          <p:spPr>
            <a:xfrm flipV="1">
              <a:off x="5974845" y="2377264"/>
              <a:ext cx="2479749" cy="26987"/>
            </a:xfrm>
            <a:prstGeom prst="straightConnector1">
              <a:avLst/>
            </a:prstGeom>
            <a:ln w="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7833938" y="2398148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Straight Arrow Connector 84"/>
            <p:cNvCxnSpPr/>
            <p:nvPr/>
          </p:nvCxnSpPr>
          <p:spPr>
            <a:xfrm flipV="1">
              <a:off x="5948709" y="2042974"/>
              <a:ext cx="0" cy="74090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/>
          <p:cNvGrpSpPr/>
          <p:nvPr/>
        </p:nvGrpSpPr>
        <p:grpSpPr>
          <a:xfrm>
            <a:off x="7374548" y="1126423"/>
            <a:ext cx="2505885" cy="740905"/>
            <a:chOff x="5948709" y="2042974"/>
            <a:chExt cx="2505885" cy="740905"/>
          </a:xfrm>
        </p:grpSpPr>
        <p:sp>
          <p:nvSpPr>
            <p:cNvPr id="67" name="Freeform 51"/>
            <p:cNvSpPr>
              <a:spLocks/>
            </p:cNvSpPr>
            <p:nvPr/>
          </p:nvSpPr>
          <p:spPr bwMode="auto">
            <a:xfrm>
              <a:off x="6395575" y="2248096"/>
              <a:ext cx="1141112" cy="364255"/>
            </a:xfrm>
            <a:custGeom>
              <a:avLst/>
              <a:gdLst>
                <a:gd name="T0" fmla="*/ 12 w 1226"/>
                <a:gd name="T1" fmla="*/ 108 h 470"/>
                <a:gd name="T2" fmla="*/ 37 w 1226"/>
                <a:gd name="T3" fmla="*/ 100 h 470"/>
                <a:gd name="T4" fmla="*/ 61 w 1226"/>
                <a:gd name="T5" fmla="*/ 87 h 470"/>
                <a:gd name="T6" fmla="*/ 82 w 1226"/>
                <a:gd name="T7" fmla="*/ 62 h 470"/>
                <a:gd name="T8" fmla="*/ 98 w 1226"/>
                <a:gd name="T9" fmla="*/ 37 h 470"/>
                <a:gd name="T10" fmla="*/ 118 w 1226"/>
                <a:gd name="T11" fmla="*/ 17 h 470"/>
                <a:gd name="T12" fmla="*/ 143 w 1226"/>
                <a:gd name="T13" fmla="*/ 4 h 470"/>
                <a:gd name="T14" fmla="*/ 167 w 1226"/>
                <a:gd name="T15" fmla="*/ 0 h 470"/>
                <a:gd name="T16" fmla="*/ 192 w 1226"/>
                <a:gd name="T17" fmla="*/ 0 h 470"/>
                <a:gd name="T18" fmla="*/ 216 w 1226"/>
                <a:gd name="T19" fmla="*/ 4 h 470"/>
                <a:gd name="T20" fmla="*/ 241 w 1226"/>
                <a:gd name="T21" fmla="*/ 21 h 470"/>
                <a:gd name="T22" fmla="*/ 265 w 1226"/>
                <a:gd name="T23" fmla="*/ 37 h 470"/>
                <a:gd name="T24" fmla="*/ 286 w 1226"/>
                <a:gd name="T25" fmla="*/ 58 h 470"/>
                <a:gd name="T26" fmla="*/ 302 w 1226"/>
                <a:gd name="T27" fmla="*/ 83 h 470"/>
                <a:gd name="T28" fmla="*/ 319 w 1226"/>
                <a:gd name="T29" fmla="*/ 108 h 470"/>
                <a:gd name="T30" fmla="*/ 339 w 1226"/>
                <a:gd name="T31" fmla="*/ 129 h 470"/>
                <a:gd name="T32" fmla="*/ 351 w 1226"/>
                <a:gd name="T33" fmla="*/ 154 h 470"/>
                <a:gd name="T34" fmla="*/ 368 w 1226"/>
                <a:gd name="T35" fmla="*/ 178 h 470"/>
                <a:gd name="T36" fmla="*/ 384 w 1226"/>
                <a:gd name="T37" fmla="*/ 203 h 470"/>
                <a:gd name="T38" fmla="*/ 392 w 1226"/>
                <a:gd name="T39" fmla="*/ 228 h 470"/>
                <a:gd name="T40" fmla="*/ 404 w 1226"/>
                <a:gd name="T41" fmla="*/ 253 h 470"/>
                <a:gd name="T42" fmla="*/ 412 w 1226"/>
                <a:gd name="T43" fmla="*/ 278 h 470"/>
                <a:gd name="T44" fmla="*/ 425 w 1226"/>
                <a:gd name="T45" fmla="*/ 303 h 470"/>
                <a:gd name="T46" fmla="*/ 441 w 1226"/>
                <a:gd name="T47" fmla="*/ 328 h 470"/>
                <a:gd name="T48" fmla="*/ 457 w 1226"/>
                <a:gd name="T49" fmla="*/ 353 h 470"/>
                <a:gd name="T50" fmla="*/ 474 w 1226"/>
                <a:gd name="T51" fmla="*/ 378 h 470"/>
                <a:gd name="T52" fmla="*/ 498 w 1226"/>
                <a:gd name="T53" fmla="*/ 403 h 470"/>
                <a:gd name="T54" fmla="*/ 519 w 1226"/>
                <a:gd name="T55" fmla="*/ 423 h 470"/>
                <a:gd name="T56" fmla="*/ 543 w 1226"/>
                <a:gd name="T57" fmla="*/ 448 h 470"/>
                <a:gd name="T58" fmla="*/ 568 w 1226"/>
                <a:gd name="T59" fmla="*/ 461 h 470"/>
                <a:gd name="T60" fmla="*/ 592 w 1226"/>
                <a:gd name="T61" fmla="*/ 469 h 470"/>
                <a:gd name="T62" fmla="*/ 617 w 1226"/>
                <a:gd name="T63" fmla="*/ 465 h 470"/>
                <a:gd name="T64" fmla="*/ 645 w 1226"/>
                <a:gd name="T65" fmla="*/ 457 h 470"/>
                <a:gd name="T66" fmla="*/ 670 w 1226"/>
                <a:gd name="T67" fmla="*/ 448 h 470"/>
                <a:gd name="T68" fmla="*/ 694 w 1226"/>
                <a:gd name="T69" fmla="*/ 432 h 470"/>
                <a:gd name="T70" fmla="*/ 715 w 1226"/>
                <a:gd name="T71" fmla="*/ 407 h 470"/>
                <a:gd name="T72" fmla="*/ 735 w 1226"/>
                <a:gd name="T73" fmla="*/ 378 h 470"/>
                <a:gd name="T74" fmla="*/ 760 w 1226"/>
                <a:gd name="T75" fmla="*/ 349 h 470"/>
                <a:gd name="T76" fmla="*/ 776 w 1226"/>
                <a:gd name="T77" fmla="*/ 324 h 470"/>
                <a:gd name="T78" fmla="*/ 792 w 1226"/>
                <a:gd name="T79" fmla="*/ 299 h 470"/>
                <a:gd name="T80" fmla="*/ 809 w 1226"/>
                <a:gd name="T81" fmla="*/ 274 h 470"/>
                <a:gd name="T82" fmla="*/ 821 w 1226"/>
                <a:gd name="T83" fmla="*/ 245 h 470"/>
                <a:gd name="T84" fmla="*/ 833 w 1226"/>
                <a:gd name="T85" fmla="*/ 216 h 470"/>
                <a:gd name="T86" fmla="*/ 845 w 1226"/>
                <a:gd name="T87" fmla="*/ 183 h 470"/>
                <a:gd name="T88" fmla="*/ 858 w 1226"/>
                <a:gd name="T89" fmla="*/ 158 h 470"/>
                <a:gd name="T90" fmla="*/ 870 w 1226"/>
                <a:gd name="T91" fmla="*/ 133 h 470"/>
                <a:gd name="T92" fmla="*/ 890 w 1226"/>
                <a:gd name="T93" fmla="*/ 108 h 470"/>
                <a:gd name="T94" fmla="*/ 907 w 1226"/>
                <a:gd name="T95" fmla="*/ 83 h 470"/>
                <a:gd name="T96" fmla="*/ 927 w 1226"/>
                <a:gd name="T97" fmla="*/ 54 h 470"/>
                <a:gd name="T98" fmla="*/ 947 w 1226"/>
                <a:gd name="T99" fmla="*/ 25 h 470"/>
                <a:gd name="T100" fmla="*/ 972 w 1226"/>
                <a:gd name="T101" fmla="*/ 12 h 470"/>
                <a:gd name="T102" fmla="*/ 1000 w 1226"/>
                <a:gd name="T103" fmla="*/ 12 h 470"/>
                <a:gd name="T104" fmla="*/ 1025 w 1226"/>
                <a:gd name="T105" fmla="*/ 21 h 470"/>
                <a:gd name="T106" fmla="*/ 1054 w 1226"/>
                <a:gd name="T107" fmla="*/ 33 h 470"/>
                <a:gd name="T108" fmla="*/ 1078 w 1226"/>
                <a:gd name="T109" fmla="*/ 50 h 470"/>
                <a:gd name="T110" fmla="*/ 1103 w 1226"/>
                <a:gd name="T111" fmla="*/ 62 h 470"/>
                <a:gd name="T112" fmla="*/ 1127 w 1226"/>
                <a:gd name="T113" fmla="*/ 79 h 470"/>
                <a:gd name="T114" fmla="*/ 1152 w 1226"/>
                <a:gd name="T115" fmla="*/ 91 h 470"/>
                <a:gd name="T116" fmla="*/ 1176 w 1226"/>
                <a:gd name="T117" fmla="*/ 104 h 470"/>
                <a:gd name="T118" fmla="*/ 1201 w 1226"/>
                <a:gd name="T119" fmla="*/ 116 h 470"/>
                <a:gd name="T120" fmla="*/ 1225 w 1226"/>
                <a:gd name="T121" fmla="*/ 120 h 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1226" h="470">
                  <a:moveTo>
                    <a:pt x="0" y="112"/>
                  </a:moveTo>
                  <a:lnTo>
                    <a:pt x="12" y="108"/>
                  </a:lnTo>
                  <a:lnTo>
                    <a:pt x="25" y="108"/>
                  </a:lnTo>
                  <a:lnTo>
                    <a:pt x="37" y="100"/>
                  </a:lnTo>
                  <a:lnTo>
                    <a:pt x="49" y="95"/>
                  </a:lnTo>
                  <a:lnTo>
                    <a:pt x="61" y="87"/>
                  </a:lnTo>
                  <a:lnTo>
                    <a:pt x="69" y="75"/>
                  </a:lnTo>
                  <a:lnTo>
                    <a:pt x="82" y="62"/>
                  </a:lnTo>
                  <a:lnTo>
                    <a:pt x="90" y="50"/>
                  </a:lnTo>
                  <a:lnTo>
                    <a:pt x="98" y="37"/>
                  </a:lnTo>
                  <a:lnTo>
                    <a:pt x="106" y="25"/>
                  </a:lnTo>
                  <a:lnTo>
                    <a:pt x="118" y="17"/>
                  </a:lnTo>
                  <a:lnTo>
                    <a:pt x="131" y="8"/>
                  </a:lnTo>
                  <a:lnTo>
                    <a:pt x="143" y="4"/>
                  </a:lnTo>
                  <a:lnTo>
                    <a:pt x="155" y="0"/>
                  </a:lnTo>
                  <a:lnTo>
                    <a:pt x="167" y="0"/>
                  </a:lnTo>
                  <a:lnTo>
                    <a:pt x="180" y="0"/>
                  </a:lnTo>
                  <a:lnTo>
                    <a:pt x="192" y="0"/>
                  </a:lnTo>
                  <a:lnTo>
                    <a:pt x="204" y="4"/>
                  </a:lnTo>
                  <a:lnTo>
                    <a:pt x="216" y="4"/>
                  </a:lnTo>
                  <a:lnTo>
                    <a:pt x="229" y="12"/>
                  </a:lnTo>
                  <a:lnTo>
                    <a:pt x="241" y="21"/>
                  </a:lnTo>
                  <a:lnTo>
                    <a:pt x="253" y="25"/>
                  </a:lnTo>
                  <a:lnTo>
                    <a:pt x="265" y="37"/>
                  </a:lnTo>
                  <a:lnTo>
                    <a:pt x="278" y="46"/>
                  </a:lnTo>
                  <a:lnTo>
                    <a:pt x="286" y="58"/>
                  </a:lnTo>
                  <a:lnTo>
                    <a:pt x="298" y="71"/>
                  </a:lnTo>
                  <a:lnTo>
                    <a:pt x="302" y="83"/>
                  </a:lnTo>
                  <a:lnTo>
                    <a:pt x="314" y="95"/>
                  </a:lnTo>
                  <a:lnTo>
                    <a:pt x="319" y="108"/>
                  </a:lnTo>
                  <a:lnTo>
                    <a:pt x="331" y="116"/>
                  </a:lnTo>
                  <a:lnTo>
                    <a:pt x="339" y="129"/>
                  </a:lnTo>
                  <a:lnTo>
                    <a:pt x="343" y="141"/>
                  </a:lnTo>
                  <a:lnTo>
                    <a:pt x="351" y="154"/>
                  </a:lnTo>
                  <a:lnTo>
                    <a:pt x="359" y="166"/>
                  </a:lnTo>
                  <a:lnTo>
                    <a:pt x="368" y="178"/>
                  </a:lnTo>
                  <a:lnTo>
                    <a:pt x="376" y="191"/>
                  </a:lnTo>
                  <a:lnTo>
                    <a:pt x="384" y="203"/>
                  </a:lnTo>
                  <a:lnTo>
                    <a:pt x="388" y="216"/>
                  </a:lnTo>
                  <a:lnTo>
                    <a:pt x="392" y="228"/>
                  </a:lnTo>
                  <a:lnTo>
                    <a:pt x="396" y="241"/>
                  </a:lnTo>
                  <a:lnTo>
                    <a:pt x="404" y="253"/>
                  </a:lnTo>
                  <a:lnTo>
                    <a:pt x="408" y="266"/>
                  </a:lnTo>
                  <a:lnTo>
                    <a:pt x="412" y="278"/>
                  </a:lnTo>
                  <a:lnTo>
                    <a:pt x="421" y="291"/>
                  </a:lnTo>
                  <a:lnTo>
                    <a:pt x="425" y="303"/>
                  </a:lnTo>
                  <a:lnTo>
                    <a:pt x="433" y="315"/>
                  </a:lnTo>
                  <a:lnTo>
                    <a:pt x="441" y="328"/>
                  </a:lnTo>
                  <a:lnTo>
                    <a:pt x="449" y="340"/>
                  </a:lnTo>
                  <a:lnTo>
                    <a:pt x="457" y="353"/>
                  </a:lnTo>
                  <a:lnTo>
                    <a:pt x="466" y="365"/>
                  </a:lnTo>
                  <a:lnTo>
                    <a:pt x="474" y="378"/>
                  </a:lnTo>
                  <a:lnTo>
                    <a:pt x="486" y="390"/>
                  </a:lnTo>
                  <a:lnTo>
                    <a:pt x="498" y="403"/>
                  </a:lnTo>
                  <a:lnTo>
                    <a:pt x="506" y="415"/>
                  </a:lnTo>
                  <a:lnTo>
                    <a:pt x="519" y="423"/>
                  </a:lnTo>
                  <a:lnTo>
                    <a:pt x="531" y="436"/>
                  </a:lnTo>
                  <a:lnTo>
                    <a:pt x="543" y="448"/>
                  </a:lnTo>
                  <a:lnTo>
                    <a:pt x="555" y="457"/>
                  </a:lnTo>
                  <a:lnTo>
                    <a:pt x="568" y="461"/>
                  </a:lnTo>
                  <a:lnTo>
                    <a:pt x="580" y="465"/>
                  </a:lnTo>
                  <a:lnTo>
                    <a:pt x="592" y="469"/>
                  </a:lnTo>
                  <a:lnTo>
                    <a:pt x="604" y="469"/>
                  </a:lnTo>
                  <a:lnTo>
                    <a:pt x="617" y="465"/>
                  </a:lnTo>
                  <a:lnTo>
                    <a:pt x="633" y="461"/>
                  </a:lnTo>
                  <a:lnTo>
                    <a:pt x="645" y="457"/>
                  </a:lnTo>
                  <a:lnTo>
                    <a:pt x="657" y="452"/>
                  </a:lnTo>
                  <a:lnTo>
                    <a:pt x="670" y="448"/>
                  </a:lnTo>
                  <a:lnTo>
                    <a:pt x="682" y="440"/>
                  </a:lnTo>
                  <a:lnTo>
                    <a:pt x="694" y="432"/>
                  </a:lnTo>
                  <a:lnTo>
                    <a:pt x="702" y="419"/>
                  </a:lnTo>
                  <a:lnTo>
                    <a:pt x="715" y="407"/>
                  </a:lnTo>
                  <a:lnTo>
                    <a:pt x="727" y="390"/>
                  </a:lnTo>
                  <a:lnTo>
                    <a:pt x="735" y="378"/>
                  </a:lnTo>
                  <a:lnTo>
                    <a:pt x="747" y="361"/>
                  </a:lnTo>
                  <a:lnTo>
                    <a:pt x="760" y="349"/>
                  </a:lnTo>
                  <a:lnTo>
                    <a:pt x="768" y="336"/>
                  </a:lnTo>
                  <a:lnTo>
                    <a:pt x="776" y="324"/>
                  </a:lnTo>
                  <a:lnTo>
                    <a:pt x="784" y="311"/>
                  </a:lnTo>
                  <a:lnTo>
                    <a:pt x="792" y="299"/>
                  </a:lnTo>
                  <a:lnTo>
                    <a:pt x="804" y="286"/>
                  </a:lnTo>
                  <a:lnTo>
                    <a:pt x="809" y="274"/>
                  </a:lnTo>
                  <a:lnTo>
                    <a:pt x="817" y="261"/>
                  </a:lnTo>
                  <a:lnTo>
                    <a:pt x="821" y="245"/>
                  </a:lnTo>
                  <a:lnTo>
                    <a:pt x="829" y="228"/>
                  </a:lnTo>
                  <a:lnTo>
                    <a:pt x="833" y="216"/>
                  </a:lnTo>
                  <a:lnTo>
                    <a:pt x="837" y="199"/>
                  </a:lnTo>
                  <a:lnTo>
                    <a:pt x="845" y="183"/>
                  </a:lnTo>
                  <a:lnTo>
                    <a:pt x="849" y="170"/>
                  </a:lnTo>
                  <a:lnTo>
                    <a:pt x="858" y="158"/>
                  </a:lnTo>
                  <a:lnTo>
                    <a:pt x="862" y="145"/>
                  </a:lnTo>
                  <a:lnTo>
                    <a:pt x="870" y="133"/>
                  </a:lnTo>
                  <a:lnTo>
                    <a:pt x="878" y="120"/>
                  </a:lnTo>
                  <a:lnTo>
                    <a:pt x="890" y="108"/>
                  </a:lnTo>
                  <a:lnTo>
                    <a:pt x="898" y="95"/>
                  </a:lnTo>
                  <a:lnTo>
                    <a:pt x="907" y="83"/>
                  </a:lnTo>
                  <a:lnTo>
                    <a:pt x="915" y="71"/>
                  </a:lnTo>
                  <a:lnTo>
                    <a:pt x="927" y="54"/>
                  </a:lnTo>
                  <a:lnTo>
                    <a:pt x="939" y="37"/>
                  </a:lnTo>
                  <a:lnTo>
                    <a:pt x="947" y="25"/>
                  </a:lnTo>
                  <a:lnTo>
                    <a:pt x="960" y="21"/>
                  </a:lnTo>
                  <a:lnTo>
                    <a:pt x="972" y="12"/>
                  </a:lnTo>
                  <a:lnTo>
                    <a:pt x="984" y="12"/>
                  </a:lnTo>
                  <a:lnTo>
                    <a:pt x="1000" y="12"/>
                  </a:lnTo>
                  <a:lnTo>
                    <a:pt x="1013" y="17"/>
                  </a:lnTo>
                  <a:lnTo>
                    <a:pt x="1025" y="21"/>
                  </a:lnTo>
                  <a:lnTo>
                    <a:pt x="1037" y="29"/>
                  </a:lnTo>
                  <a:lnTo>
                    <a:pt x="1054" y="33"/>
                  </a:lnTo>
                  <a:lnTo>
                    <a:pt x="1066" y="42"/>
                  </a:lnTo>
                  <a:lnTo>
                    <a:pt x="1078" y="50"/>
                  </a:lnTo>
                  <a:lnTo>
                    <a:pt x="1090" y="58"/>
                  </a:lnTo>
                  <a:lnTo>
                    <a:pt x="1103" y="62"/>
                  </a:lnTo>
                  <a:lnTo>
                    <a:pt x="1115" y="71"/>
                  </a:lnTo>
                  <a:lnTo>
                    <a:pt x="1127" y="79"/>
                  </a:lnTo>
                  <a:lnTo>
                    <a:pt x="1139" y="87"/>
                  </a:lnTo>
                  <a:lnTo>
                    <a:pt x="1152" y="91"/>
                  </a:lnTo>
                  <a:lnTo>
                    <a:pt x="1164" y="100"/>
                  </a:lnTo>
                  <a:lnTo>
                    <a:pt x="1176" y="104"/>
                  </a:lnTo>
                  <a:lnTo>
                    <a:pt x="1188" y="112"/>
                  </a:lnTo>
                  <a:lnTo>
                    <a:pt x="1201" y="116"/>
                  </a:lnTo>
                  <a:lnTo>
                    <a:pt x="1213" y="116"/>
                  </a:lnTo>
                  <a:lnTo>
                    <a:pt x="1225" y="120"/>
                  </a:lnTo>
                </a:path>
              </a:pathLst>
            </a:custGeom>
            <a:noFill/>
            <a:ln w="28575" cap="rnd" cmpd="sng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87956" tIns="43206" rIns="87956" bIns="43206">
              <a:spAutoFit/>
            </a:bodyPr>
            <a:lstStyle/>
            <a:p>
              <a:endParaRPr lang="en-US"/>
            </a:p>
          </p:txBody>
        </p:sp>
        <p:cxnSp>
          <p:nvCxnSpPr>
            <p:cNvPr id="6" name="Straight Arrow Connector 5"/>
            <p:cNvCxnSpPr/>
            <p:nvPr/>
          </p:nvCxnSpPr>
          <p:spPr>
            <a:xfrm flipV="1">
              <a:off x="5974845" y="2377264"/>
              <a:ext cx="2479749" cy="26987"/>
            </a:xfrm>
            <a:prstGeom prst="straightConnector1">
              <a:avLst/>
            </a:prstGeom>
            <a:ln w="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7833938" y="2398148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V="1">
              <a:off x="5948709" y="2042974"/>
              <a:ext cx="0" cy="74090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6" name="Group 85"/>
          <p:cNvGrpSpPr/>
          <p:nvPr/>
        </p:nvGrpSpPr>
        <p:grpSpPr>
          <a:xfrm>
            <a:off x="7404317" y="2046201"/>
            <a:ext cx="2505885" cy="740905"/>
            <a:chOff x="5948709" y="2042974"/>
            <a:chExt cx="2505885" cy="740905"/>
          </a:xfrm>
        </p:grpSpPr>
        <p:sp>
          <p:nvSpPr>
            <p:cNvPr id="87" name="Freeform 51"/>
            <p:cNvSpPr>
              <a:spLocks/>
            </p:cNvSpPr>
            <p:nvPr/>
          </p:nvSpPr>
          <p:spPr bwMode="auto">
            <a:xfrm>
              <a:off x="6840418" y="2248096"/>
              <a:ext cx="1141112" cy="364255"/>
            </a:xfrm>
            <a:custGeom>
              <a:avLst/>
              <a:gdLst>
                <a:gd name="T0" fmla="*/ 12 w 1226"/>
                <a:gd name="T1" fmla="*/ 108 h 470"/>
                <a:gd name="T2" fmla="*/ 37 w 1226"/>
                <a:gd name="T3" fmla="*/ 100 h 470"/>
                <a:gd name="T4" fmla="*/ 61 w 1226"/>
                <a:gd name="T5" fmla="*/ 87 h 470"/>
                <a:gd name="T6" fmla="*/ 82 w 1226"/>
                <a:gd name="T7" fmla="*/ 62 h 470"/>
                <a:gd name="T8" fmla="*/ 98 w 1226"/>
                <a:gd name="T9" fmla="*/ 37 h 470"/>
                <a:gd name="T10" fmla="*/ 118 w 1226"/>
                <a:gd name="T11" fmla="*/ 17 h 470"/>
                <a:gd name="T12" fmla="*/ 143 w 1226"/>
                <a:gd name="T13" fmla="*/ 4 h 470"/>
                <a:gd name="T14" fmla="*/ 167 w 1226"/>
                <a:gd name="T15" fmla="*/ 0 h 470"/>
                <a:gd name="T16" fmla="*/ 192 w 1226"/>
                <a:gd name="T17" fmla="*/ 0 h 470"/>
                <a:gd name="T18" fmla="*/ 216 w 1226"/>
                <a:gd name="T19" fmla="*/ 4 h 470"/>
                <a:gd name="T20" fmla="*/ 241 w 1226"/>
                <a:gd name="T21" fmla="*/ 21 h 470"/>
                <a:gd name="T22" fmla="*/ 265 w 1226"/>
                <a:gd name="T23" fmla="*/ 37 h 470"/>
                <a:gd name="T24" fmla="*/ 286 w 1226"/>
                <a:gd name="T25" fmla="*/ 58 h 470"/>
                <a:gd name="T26" fmla="*/ 302 w 1226"/>
                <a:gd name="T27" fmla="*/ 83 h 470"/>
                <a:gd name="T28" fmla="*/ 319 w 1226"/>
                <a:gd name="T29" fmla="*/ 108 h 470"/>
                <a:gd name="T30" fmla="*/ 339 w 1226"/>
                <a:gd name="T31" fmla="*/ 129 h 470"/>
                <a:gd name="T32" fmla="*/ 351 w 1226"/>
                <a:gd name="T33" fmla="*/ 154 h 470"/>
                <a:gd name="T34" fmla="*/ 368 w 1226"/>
                <a:gd name="T35" fmla="*/ 178 h 470"/>
                <a:gd name="T36" fmla="*/ 384 w 1226"/>
                <a:gd name="T37" fmla="*/ 203 h 470"/>
                <a:gd name="T38" fmla="*/ 392 w 1226"/>
                <a:gd name="T39" fmla="*/ 228 h 470"/>
                <a:gd name="T40" fmla="*/ 404 w 1226"/>
                <a:gd name="T41" fmla="*/ 253 h 470"/>
                <a:gd name="T42" fmla="*/ 412 w 1226"/>
                <a:gd name="T43" fmla="*/ 278 h 470"/>
                <a:gd name="T44" fmla="*/ 425 w 1226"/>
                <a:gd name="T45" fmla="*/ 303 h 470"/>
                <a:gd name="T46" fmla="*/ 441 w 1226"/>
                <a:gd name="T47" fmla="*/ 328 h 470"/>
                <a:gd name="T48" fmla="*/ 457 w 1226"/>
                <a:gd name="T49" fmla="*/ 353 h 470"/>
                <a:gd name="T50" fmla="*/ 474 w 1226"/>
                <a:gd name="T51" fmla="*/ 378 h 470"/>
                <a:gd name="T52" fmla="*/ 498 w 1226"/>
                <a:gd name="T53" fmla="*/ 403 h 470"/>
                <a:gd name="T54" fmla="*/ 519 w 1226"/>
                <a:gd name="T55" fmla="*/ 423 h 470"/>
                <a:gd name="T56" fmla="*/ 543 w 1226"/>
                <a:gd name="T57" fmla="*/ 448 h 470"/>
                <a:gd name="T58" fmla="*/ 568 w 1226"/>
                <a:gd name="T59" fmla="*/ 461 h 470"/>
                <a:gd name="T60" fmla="*/ 592 w 1226"/>
                <a:gd name="T61" fmla="*/ 469 h 470"/>
                <a:gd name="T62" fmla="*/ 617 w 1226"/>
                <a:gd name="T63" fmla="*/ 465 h 470"/>
                <a:gd name="T64" fmla="*/ 645 w 1226"/>
                <a:gd name="T65" fmla="*/ 457 h 470"/>
                <a:gd name="T66" fmla="*/ 670 w 1226"/>
                <a:gd name="T67" fmla="*/ 448 h 470"/>
                <a:gd name="T68" fmla="*/ 694 w 1226"/>
                <a:gd name="T69" fmla="*/ 432 h 470"/>
                <a:gd name="T70" fmla="*/ 715 w 1226"/>
                <a:gd name="T71" fmla="*/ 407 h 470"/>
                <a:gd name="T72" fmla="*/ 735 w 1226"/>
                <a:gd name="T73" fmla="*/ 378 h 470"/>
                <a:gd name="T74" fmla="*/ 760 w 1226"/>
                <a:gd name="T75" fmla="*/ 349 h 470"/>
                <a:gd name="T76" fmla="*/ 776 w 1226"/>
                <a:gd name="T77" fmla="*/ 324 h 470"/>
                <a:gd name="T78" fmla="*/ 792 w 1226"/>
                <a:gd name="T79" fmla="*/ 299 h 470"/>
                <a:gd name="T80" fmla="*/ 809 w 1226"/>
                <a:gd name="T81" fmla="*/ 274 h 470"/>
                <a:gd name="T82" fmla="*/ 821 w 1226"/>
                <a:gd name="T83" fmla="*/ 245 h 470"/>
                <a:gd name="T84" fmla="*/ 833 w 1226"/>
                <a:gd name="T85" fmla="*/ 216 h 470"/>
                <a:gd name="T86" fmla="*/ 845 w 1226"/>
                <a:gd name="T87" fmla="*/ 183 h 470"/>
                <a:gd name="T88" fmla="*/ 858 w 1226"/>
                <a:gd name="T89" fmla="*/ 158 h 470"/>
                <a:gd name="T90" fmla="*/ 870 w 1226"/>
                <a:gd name="T91" fmla="*/ 133 h 470"/>
                <a:gd name="T92" fmla="*/ 890 w 1226"/>
                <a:gd name="T93" fmla="*/ 108 h 470"/>
                <a:gd name="T94" fmla="*/ 907 w 1226"/>
                <a:gd name="T95" fmla="*/ 83 h 470"/>
                <a:gd name="T96" fmla="*/ 927 w 1226"/>
                <a:gd name="T97" fmla="*/ 54 h 470"/>
                <a:gd name="T98" fmla="*/ 947 w 1226"/>
                <a:gd name="T99" fmla="*/ 25 h 470"/>
                <a:gd name="T100" fmla="*/ 972 w 1226"/>
                <a:gd name="T101" fmla="*/ 12 h 470"/>
                <a:gd name="T102" fmla="*/ 1000 w 1226"/>
                <a:gd name="T103" fmla="*/ 12 h 470"/>
                <a:gd name="T104" fmla="*/ 1025 w 1226"/>
                <a:gd name="T105" fmla="*/ 21 h 470"/>
                <a:gd name="T106" fmla="*/ 1054 w 1226"/>
                <a:gd name="T107" fmla="*/ 33 h 470"/>
                <a:gd name="T108" fmla="*/ 1078 w 1226"/>
                <a:gd name="T109" fmla="*/ 50 h 470"/>
                <a:gd name="T110" fmla="*/ 1103 w 1226"/>
                <a:gd name="T111" fmla="*/ 62 h 470"/>
                <a:gd name="T112" fmla="*/ 1127 w 1226"/>
                <a:gd name="T113" fmla="*/ 79 h 470"/>
                <a:gd name="T114" fmla="*/ 1152 w 1226"/>
                <a:gd name="T115" fmla="*/ 91 h 470"/>
                <a:gd name="T116" fmla="*/ 1176 w 1226"/>
                <a:gd name="T117" fmla="*/ 104 h 470"/>
                <a:gd name="T118" fmla="*/ 1201 w 1226"/>
                <a:gd name="T119" fmla="*/ 116 h 470"/>
                <a:gd name="T120" fmla="*/ 1225 w 1226"/>
                <a:gd name="T121" fmla="*/ 120 h 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1226" h="470">
                  <a:moveTo>
                    <a:pt x="0" y="112"/>
                  </a:moveTo>
                  <a:lnTo>
                    <a:pt x="12" y="108"/>
                  </a:lnTo>
                  <a:lnTo>
                    <a:pt x="25" y="108"/>
                  </a:lnTo>
                  <a:lnTo>
                    <a:pt x="37" y="100"/>
                  </a:lnTo>
                  <a:lnTo>
                    <a:pt x="49" y="95"/>
                  </a:lnTo>
                  <a:lnTo>
                    <a:pt x="61" y="87"/>
                  </a:lnTo>
                  <a:lnTo>
                    <a:pt x="69" y="75"/>
                  </a:lnTo>
                  <a:lnTo>
                    <a:pt x="82" y="62"/>
                  </a:lnTo>
                  <a:lnTo>
                    <a:pt x="90" y="50"/>
                  </a:lnTo>
                  <a:lnTo>
                    <a:pt x="98" y="37"/>
                  </a:lnTo>
                  <a:lnTo>
                    <a:pt x="106" y="25"/>
                  </a:lnTo>
                  <a:lnTo>
                    <a:pt x="118" y="17"/>
                  </a:lnTo>
                  <a:lnTo>
                    <a:pt x="131" y="8"/>
                  </a:lnTo>
                  <a:lnTo>
                    <a:pt x="143" y="4"/>
                  </a:lnTo>
                  <a:lnTo>
                    <a:pt x="155" y="0"/>
                  </a:lnTo>
                  <a:lnTo>
                    <a:pt x="167" y="0"/>
                  </a:lnTo>
                  <a:lnTo>
                    <a:pt x="180" y="0"/>
                  </a:lnTo>
                  <a:lnTo>
                    <a:pt x="192" y="0"/>
                  </a:lnTo>
                  <a:lnTo>
                    <a:pt x="204" y="4"/>
                  </a:lnTo>
                  <a:lnTo>
                    <a:pt x="216" y="4"/>
                  </a:lnTo>
                  <a:lnTo>
                    <a:pt x="229" y="12"/>
                  </a:lnTo>
                  <a:lnTo>
                    <a:pt x="241" y="21"/>
                  </a:lnTo>
                  <a:lnTo>
                    <a:pt x="253" y="25"/>
                  </a:lnTo>
                  <a:lnTo>
                    <a:pt x="265" y="37"/>
                  </a:lnTo>
                  <a:lnTo>
                    <a:pt x="278" y="46"/>
                  </a:lnTo>
                  <a:lnTo>
                    <a:pt x="286" y="58"/>
                  </a:lnTo>
                  <a:lnTo>
                    <a:pt x="298" y="71"/>
                  </a:lnTo>
                  <a:lnTo>
                    <a:pt x="302" y="83"/>
                  </a:lnTo>
                  <a:lnTo>
                    <a:pt x="314" y="95"/>
                  </a:lnTo>
                  <a:lnTo>
                    <a:pt x="319" y="108"/>
                  </a:lnTo>
                  <a:lnTo>
                    <a:pt x="331" y="116"/>
                  </a:lnTo>
                  <a:lnTo>
                    <a:pt x="339" y="129"/>
                  </a:lnTo>
                  <a:lnTo>
                    <a:pt x="343" y="141"/>
                  </a:lnTo>
                  <a:lnTo>
                    <a:pt x="351" y="154"/>
                  </a:lnTo>
                  <a:lnTo>
                    <a:pt x="359" y="166"/>
                  </a:lnTo>
                  <a:lnTo>
                    <a:pt x="368" y="178"/>
                  </a:lnTo>
                  <a:lnTo>
                    <a:pt x="376" y="191"/>
                  </a:lnTo>
                  <a:lnTo>
                    <a:pt x="384" y="203"/>
                  </a:lnTo>
                  <a:lnTo>
                    <a:pt x="388" y="216"/>
                  </a:lnTo>
                  <a:lnTo>
                    <a:pt x="392" y="228"/>
                  </a:lnTo>
                  <a:lnTo>
                    <a:pt x="396" y="241"/>
                  </a:lnTo>
                  <a:lnTo>
                    <a:pt x="404" y="253"/>
                  </a:lnTo>
                  <a:lnTo>
                    <a:pt x="408" y="266"/>
                  </a:lnTo>
                  <a:lnTo>
                    <a:pt x="412" y="278"/>
                  </a:lnTo>
                  <a:lnTo>
                    <a:pt x="421" y="291"/>
                  </a:lnTo>
                  <a:lnTo>
                    <a:pt x="425" y="303"/>
                  </a:lnTo>
                  <a:lnTo>
                    <a:pt x="433" y="315"/>
                  </a:lnTo>
                  <a:lnTo>
                    <a:pt x="441" y="328"/>
                  </a:lnTo>
                  <a:lnTo>
                    <a:pt x="449" y="340"/>
                  </a:lnTo>
                  <a:lnTo>
                    <a:pt x="457" y="353"/>
                  </a:lnTo>
                  <a:lnTo>
                    <a:pt x="466" y="365"/>
                  </a:lnTo>
                  <a:lnTo>
                    <a:pt x="474" y="378"/>
                  </a:lnTo>
                  <a:lnTo>
                    <a:pt x="486" y="390"/>
                  </a:lnTo>
                  <a:lnTo>
                    <a:pt x="498" y="403"/>
                  </a:lnTo>
                  <a:lnTo>
                    <a:pt x="506" y="415"/>
                  </a:lnTo>
                  <a:lnTo>
                    <a:pt x="519" y="423"/>
                  </a:lnTo>
                  <a:lnTo>
                    <a:pt x="531" y="436"/>
                  </a:lnTo>
                  <a:lnTo>
                    <a:pt x="543" y="448"/>
                  </a:lnTo>
                  <a:lnTo>
                    <a:pt x="555" y="457"/>
                  </a:lnTo>
                  <a:lnTo>
                    <a:pt x="568" y="461"/>
                  </a:lnTo>
                  <a:lnTo>
                    <a:pt x="580" y="465"/>
                  </a:lnTo>
                  <a:lnTo>
                    <a:pt x="592" y="469"/>
                  </a:lnTo>
                  <a:lnTo>
                    <a:pt x="604" y="469"/>
                  </a:lnTo>
                  <a:lnTo>
                    <a:pt x="617" y="465"/>
                  </a:lnTo>
                  <a:lnTo>
                    <a:pt x="633" y="461"/>
                  </a:lnTo>
                  <a:lnTo>
                    <a:pt x="645" y="457"/>
                  </a:lnTo>
                  <a:lnTo>
                    <a:pt x="657" y="452"/>
                  </a:lnTo>
                  <a:lnTo>
                    <a:pt x="670" y="448"/>
                  </a:lnTo>
                  <a:lnTo>
                    <a:pt x="682" y="440"/>
                  </a:lnTo>
                  <a:lnTo>
                    <a:pt x="694" y="432"/>
                  </a:lnTo>
                  <a:lnTo>
                    <a:pt x="702" y="419"/>
                  </a:lnTo>
                  <a:lnTo>
                    <a:pt x="715" y="407"/>
                  </a:lnTo>
                  <a:lnTo>
                    <a:pt x="727" y="390"/>
                  </a:lnTo>
                  <a:lnTo>
                    <a:pt x="735" y="378"/>
                  </a:lnTo>
                  <a:lnTo>
                    <a:pt x="747" y="361"/>
                  </a:lnTo>
                  <a:lnTo>
                    <a:pt x="760" y="349"/>
                  </a:lnTo>
                  <a:lnTo>
                    <a:pt x="768" y="336"/>
                  </a:lnTo>
                  <a:lnTo>
                    <a:pt x="776" y="324"/>
                  </a:lnTo>
                  <a:lnTo>
                    <a:pt x="784" y="311"/>
                  </a:lnTo>
                  <a:lnTo>
                    <a:pt x="792" y="299"/>
                  </a:lnTo>
                  <a:lnTo>
                    <a:pt x="804" y="286"/>
                  </a:lnTo>
                  <a:lnTo>
                    <a:pt x="809" y="274"/>
                  </a:lnTo>
                  <a:lnTo>
                    <a:pt x="817" y="261"/>
                  </a:lnTo>
                  <a:lnTo>
                    <a:pt x="821" y="245"/>
                  </a:lnTo>
                  <a:lnTo>
                    <a:pt x="829" y="228"/>
                  </a:lnTo>
                  <a:lnTo>
                    <a:pt x="833" y="216"/>
                  </a:lnTo>
                  <a:lnTo>
                    <a:pt x="837" y="199"/>
                  </a:lnTo>
                  <a:lnTo>
                    <a:pt x="845" y="183"/>
                  </a:lnTo>
                  <a:lnTo>
                    <a:pt x="849" y="170"/>
                  </a:lnTo>
                  <a:lnTo>
                    <a:pt x="858" y="158"/>
                  </a:lnTo>
                  <a:lnTo>
                    <a:pt x="862" y="145"/>
                  </a:lnTo>
                  <a:lnTo>
                    <a:pt x="870" y="133"/>
                  </a:lnTo>
                  <a:lnTo>
                    <a:pt x="878" y="120"/>
                  </a:lnTo>
                  <a:lnTo>
                    <a:pt x="890" y="108"/>
                  </a:lnTo>
                  <a:lnTo>
                    <a:pt x="898" y="95"/>
                  </a:lnTo>
                  <a:lnTo>
                    <a:pt x="907" y="83"/>
                  </a:lnTo>
                  <a:lnTo>
                    <a:pt x="915" y="71"/>
                  </a:lnTo>
                  <a:lnTo>
                    <a:pt x="927" y="54"/>
                  </a:lnTo>
                  <a:lnTo>
                    <a:pt x="939" y="37"/>
                  </a:lnTo>
                  <a:lnTo>
                    <a:pt x="947" y="25"/>
                  </a:lnTo>
                  <a:lnTo>
                    <a:pt x="960" y="21"/>
                  </a:lnTo>
                  <a:lnTo>
                    <a:pt x="972" y="12"/>
                  </a:lnTo>
                  <a:lnTo>
                    <a:pt x="984" y="12"/>
                  </a:lnTo>
                  <a:lnTo>
                    <a:pt x="1000" y="12"/>
                  </a:lnTo>
                  <a:lnTo>
                    <a:pt x="1013" y="17"/>
                  </a:lnTo>
                  <a:lnTo>
                    <a:pt x="1025" y="21"/>
                  </a:lnTo>
                  <a:lnTo>
                    <a:pt x="1037" y="29"/>
                  </a:lnTo>
                  <a:lnTo>
                    <a:pt x="1054" y="33"/>
                  </a:lnTo>
                  <a:lnTo>
                    <a:pt x="1066" y="42"/>
                  </a:lnTo>
                  <a:lnTo>
                    <a:pt x="1078" y="50"/>
                  </a:lnTo>
                  <a:lnTo>
                    <a:pt x="1090" y="58"/>
                  </a:lnTo>
                  <a:lnTo>
                    <a:pt x="1103" y="62"/>
                  </a:lnTo>
                  <a:lnTo>
                    <a:pt x="1115" y="71"/>
                  </a:lnTo>
                  <a:lnTo>
                    <a:pt x="1127" y="79"/>
                  </a:lnTo>
                  <a:lnTo>
                    <a:pt x="1139" y="87"/>
                  </a:lnTo>
                  <a:lnTo>
                    <a:pt x="1152" y="91"/>
                  </a:lnTo>
                  <a:lnTo>
                    <a:pt x="1164" y="100"/>
                  </a:lnTo>
                  <a:lnTo>
                    <a:pt x="1176" y="104"/>
                  </a:lnTo>
                  <a:lnTo>
                    <a:pt x="1188" y="112"/>
                  </a:lnTo>
                  <a:lnTo>
                    <a:pt x="1201" y="116"/>
                  </a:lnTo>
                  <a:lnTo>
                    <a:pt x="1213" y="116"/>
                  </a:lnTo>
                  <a:lnTo>
                    <a:pt x="1225" y="120"/>
                  </a:lnTo>
                </a:path>
              </a:pathLst>
            </a:custGeom>
            <a:noFill/>
            <a:ln w="28575" cap="rnd" cmpd="sng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87956" tIns="43206" rIns="87956" bIns="43206">
              <a:spAutoFit/>
            </a:bodyPr>
            <a:lstStyle/>
            <a:p>
              <a:endParaRPr lang="en-US"/>
            </a:p>
          </p:txBody>
        </p:sp>
        <p:cxnSp>
          <p:nvCxnSpPr>
            <p:cNvPr id="88" name="Straight Arrow Connector 87"/>
            <p:cNvCxnSpPr/>
            <p:nvPr/>
          </p:nvCxnSpPr>
          <p:spPr>
            <a:xfrm flipV="1">
              <a:off x="5974845" y="2377264"/>
              <a:ext cx="2479749" cy="26987"/>
            </a:xfrm>
            <a:prstGeom prst="straightConnector1">
              <a:avLst/>
            </a:prstGeom>
            <a:ln w="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/>
            <p:cNvSpPr txBox="1"/>
            <p:nvPr/>
          </p:nvSpPr>
          <p:spPr>
            <a:xfrm>
              <a:off x="7833938" y="2398148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Straight Arrow Connector 89"/>
            <p:cNvCxnSpPr/>
            <p:nvPr/>
          </p:nvCxnSpPr>
          <p:spPr>
            <a:xfrm flipV="1">
              <a:off x="5948709" y="2042974"/>
              <a:ext cx="0" cy="74090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1" name="TextBox 90"/>
          <p:cNvSpPr txBox="1"/>
          <p:nvPr/>
        </p:nvSpPr>
        <p:spPr>
          <a:xfrm>
            <a:off x="6871786" y="43049"/>
            <a:ext cx="5261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it-IT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6863036" y="978075"/>
            <a:ext cx="5261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it-IT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P2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6883872" y="1938841"/>
            <a:ext cx="5261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it-IT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60"/>
          <p:cNvSpPr>
            <a:spLocks noChangeArrowheads="1"/>
          </p:cNvSpPr>
          <p:nvPr/>
        </p:nvSpPr>
        <p:spPr bwMode="auto">
          <a:xfrm>
            <a:off x="10515600" y="2673118"/>
            <a:ext cx="2071686" cy="898706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1D1BC920-5409-4C3A-B90B-CA96AE37E541}"/>
              </a:ext>
            </a:extLst>
          </p:cNvPr>
          <p:cNvGrpSpPr/>
          <p:nvPr/>
        </p:nvGrpSpPr>
        <p:grpSpPr>
          <a:xfrm>
            <a:off x="7923630" y="424060"/>
            <a:ext cx="946673" cy="2589740"/>
            <a:chOff x="7923630" y="424060"/>
            <a:chExt cx="946673" cy="2589740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B50F6BDE-B937-4E80-B454-40385F21DB55}"/>
                </a:ext>
              </a:extLst>
            </p:cNvPr>
            <p:cNvGrpSpPr/>
            <p:nvPr/>
          </p:nvGrpSpPr>
          <p:grpSpPr>
            <a:xfrm>
              <a:off x="7923630" y="424060"/>
              <a:ext cx="946673" cy="2316680"/>
              <a:chOff x="7921987" y="424576"/>
              <a:chExt cx="927074" cy="2282840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6696338F-A04E-4732-B340-C86D82335B85}"/>
                  </a:ext>
                </a:extLst>
              </p:cNvPr>
              <p:cNvCxnSpPr>
                <a:cxnSpLocks/>
                <a:endCxn id="87" idx="31"/>
              </p:cNvCxnSpPr>
              <p:nvPr/>
            </p:nvCxnSpPr>
            <p:spPr>
              <a:xfrm>
                <a:off x="7921987" y="583130"/>
                <a:ext cx="927074" cy="1997138"/>
              </a:xfrm>
              <a:prstGeom prst="line">
                <a:avLst/>
              </a:prstGeom>
              <a:ln w="25400">
                <a:solidFill>
                  <a:srgbClr val="00B050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857B3CFC-7CAF-47A0-B32A-4B515130DC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51756" y="424576"/>
                <a:ext cx="41212" cy="2282336"/>
              </a:xfrm>
              <a:prstGeom prst="line">
                <a:avLst/>
              </a:prstGeom>
              <a:ln w="158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Arrow Connector 14">
                <a:extLst>
                  <a:ext uri="{FF2B5EF4-FFF2-40B4-BE49-F238E27FC236}">
                    <a16:creationId xmlns:a16="http://schemas.microsoft.com/office/drawing/2014/main" id="{40FA586F-AA00-45ED-8531-53B2D57B6BD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004569" y="2705710"/>
                <a:ext cx="844492" cy="1706"/>
              </a:xfrm>
              <a:prstGeom prst="straightConnector1">
                <a:avLst/>
              </a:prstGeom>
              <a:ln w="12700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2535827-4097-4762-90E2-773E5332AEBD}"/>
                </a:ext>
              </a:extLst>
            </p:cNvPr>
            <p:cNvSpPr txBox="1"/>
            <p:nvPr/>
          </p:nvSpPr>
          <p:spPr>
            <a:xfrm>
              <a:off x="8075399" y="2701460"/>
              <a:ext cx="774897" cy="312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lay</a:t>
              </a:r>
            </a:p>
          </p:txBody>
        </p:sp>
      </p:grpSp>
      <p:sp>
        <p:nvSpPr>
          <p:cNvPr id="12" name="Rectangle 11"/>
          <p:cNvSpPr/>
          <p:nvPr/>
        </p:nvSpPr>
        <p:spPr>
          <a:xfrm>
            <a:off x="6903553" y="-151200"/>
            <a:ext cx="3772870" cy="31032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41031A8-9B72-41B5-9DD4-83E1734DB6B3}"/>
              </a:ext>
            </a:extLst>
          </p:cNvPr>
          <p:cNvSpPr txBox="1"/>
          <p:nvPr/>
        </p:nvSpPr>
        <p:spPr>
          <a:xfrm>
            <a:off x="10748283" y="6251507"/>
            <a:ext cx="1153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. 5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CCE0674-0CD9-456B-9807-DCF670AF0D3A}"/>
              </a:ext>
            </a:extLst>
          </p:cNvPr>
          <p:cNvCxnSpPr/>
          <p:nvPr/>
        </p:nvCxnSpPr>
        <p:spPr>
          <a:xfrm>
            <a:off x="3816350" y="6045530"/>
            <a:ext cx="619655" cy="0"/>
          </a:xfrm>
          <a:prstGeom prst="line">
            <a:avLst/>
          </a:prstGeom>
          <a:ln w="19050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8A7F3032-166A-47D3-A4E5-9E71ACAAF3AA}"/>
              </a:ext>
            </a:extLst>
          </p:cNvPr>
          <p:cNvSpPr txBox="1"/>
          <p:nvPr/>
        </p:nvSpPr>
        <p:spPr>
          <a:xfrm>
            <a:off x="3241914" y="3321166"/>
            <a:ext cx="20409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agating MUAP</a:t>
            </a:r>
          </a:p>
        </p:txBody>
      </p:sp>
      <p:sp>
        <p:nvSpPr>
          <p:cNvPr id="83" name="Down Arrow 1">
            <a:extLst>
              <a:ext uri="{FF2B5EF4-FFF2-40B4-BE49-F238E27FC236}">
                <a16:creationId xmlns:a16="http://schemas.microsoft.com/office/drawing/2014/main" id="{56611C41-46FF-4E26-BD4B-712E2F840E38}"/>
              </a:ext>
            </a:extLst>
          </p:cNvPr>
          <p:cNvSpPr/>
          <p:nvPr/>
        </p:nvSpPr>
        <p:spPr>
          <a:xfrm>
            <a:off x="2496020" y="2474401"/>
            <a:ext cx="85061" cy="146379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Down Arrow 1">
            <a:extLst>
              <a:ext uri="{FF2B5EF4-FFF2-40B4-BE49-F238E27FC236}">
                <a16:creationId xmlns:a16="http://schemas.microsoft.com/office/drawing/2014/main" id="{BF180B1F-964F-49A3-8719-3EAAF1E057FF}"/>
              </a:ext>
            </a:extLst>
          </p:cNvPr>
          <p:cNvSpPr/>
          <p:nvPr/>
        </p:nvSpPr>
        <p:spPr>
          <a:xfrm>
            <a:off x="5907938" y="2328142"/>
            <a:ext cx="85061" cy="161017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C1CBA25-695B-4F29-A40A-2E142B621453}"/>
              </a:ext>
            </a:extLst>
          </p:cNvPr>
          <p:cNvSpPr txBox="1"/>
          <p:nvPr/>
        </p:nvSpPr>
        <p:spPr>
          <a:xfrm>
            <a:off x="2369082" y="2092983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AC540AE-8BD2-4CA9-AF84-E5EDFE8280F2}"/>
              </a:ext>
            </a:extLst>
          </p:cNvPr>
          <p:cNvSpPr txBox="1"/>
          <p:nvPr/>
        </p:nvSpPr>
        <p:spPr>
          <a:xfrm>
            <a:off x="5814094" y="2012473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3995370"/>
      </p:ext>
    </p:extLst>
  </p:cSld>
  <p:clrMapOvr>
    <a:masterClrMapping/>
  </p:clrMapOvr>
  <p:transition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0" presetClass="path" presetSubtype="0" decel="200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4.16667E-6 1.85185E-6 L 0.66445 0.00162 " pathEditMode="relative" rAng="0" ptsTypes="AA">
                                      <p:cBhvr>
                                        <p:cTn id="6" dur="5000" fill="hold"/>
                                        <p:tgtEl>
                                          <p:spTgt spid="2053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33216" y="69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10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8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" presetID="0" presetClass="pat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-1.85185E-6 L 0.63264 0.00324 " pathEditMode="relative" rAng="0" ptsTypes="AA">
                                      <p:cBhvr>
                                        <p:cTn id="11" dur="5000" fill="hold"/>
                                        <p:tgtEl>
                                          <p:spTgt spid="2049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31632" y="162"/>
                                    </p:animMotion>
                                  </p:childTnLst>
                                </p:cTn>
                              </p:par>
                              <p:par>
                                <p:cTn id="12" presetID="0" presetClass="pat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6 2.59259E-6 L 0.6243 0.00023 " pathEditMode="relative" rAng="0" ptsTypes="AA">
                                      <p:cBhvr>
                                        <p:cTn id="13" dur="5000" fill="hold"/>
                                        <p:tgtEl>
                                          <p:spTgt spid="2051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31215" y="0"/>
                                    </p:animMotion>
                                  </p:childTnLst>
                                </p:cTn>
                              </p:par>
                              <p:par>
                                <p:cTn id="14" presetID="0" presetClass="pat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2.77778E-7 3.7037E-7 L 0.63316 0.00579 " pathEditMode="relative" rAng="0" ptsTypes="AA">
                                      <p:cBhvr>
                                        <p:cTn id="15" dur="5000" fill="hold"/>
                                        <p:tgtEl>
                                          <p:spTgt spid="2049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31649" y="278"/>
                                    </p:animMotion>
                                  </p:childTnLst>
                                </p:cTn>
                              </p:par>
                              <p:par>
                                <p:cTn id="16" presetID="35" presetClass="path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2.77556E-17 -2.96296E-6 L -0.27331 -0.00139 " pathEditMode="relative" rAng="0" ptsTypes="AA">
                                      <p:cBhvr>
                                        <p:cTn id="17" dur="5000" fill="hold"/>
                                        <p:tgtEl>
                                          <p:spTgt spid="2049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3672" y="-69"/>
                                    </p:animMotion>
                                  </p:childTnLst>
                                </p:cTn>
                              </p:par>
                              <p:par>
                                <p:cTn id="18" presetID="0" presetClass="pat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2.70833E-6 3.7037E-6 L -0.32487 3.7037E-6 " pathEditMode="relative" rAng="0" ptsTypes="AA">
                                      <p:cBhvr>
                                        <p:cTn id="19" dur="5000" fill="hold"/>
                                        <p:tgtEl>
                                          <p:spTgt spid="2053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6250" y="0"/>
                                    </p:animMotion>
                                  </p:childTnLst>
                                </p:cTn>
                              </p:par>
                              <p:par>
                                <p:cTn id="20" presetID="0" presetClass="pat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1.85185E-6 L -0.32483 -1.85185E-6 " pathEditMode="relative" rAng="0" ptsTypes="AA">
                                      <p:cBhvr>
                                        <p:cTn id="21" dur="5000" fill="hold"/>
                                        <p:tgtEl>
                                          <p:spTgt spid="2049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6250" y="0"/>
                                    </p:animMotion>
                                  </p:childTnLst>
                                </p:cTn>
                              </p:par>
                              <p:par>
                                <p:cTn id="22" presetID="0" presetClass="pat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2.59259E-6 L -0.32482 2.59259E-6 " pathEditMode="relative" rAng="0" ptsTypes="AA">
                                      <p:cBhvr>
                                        <p:cTn id="23" dur="5000" fill="hold"/>
                                        <p:tgtEl>
                                          <p:spTgt spid="2051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6250" y="0"/>
                                    </p:animMotion>
                                  </p:childTnLst>
                                </p:cTn>
                              </p:par>
                              <p:par>
                                <p:cTn id="24" presetID="63" presetClass="path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54167E-6 3.33333E-6 L 0.43164 3.33333E-6 " pathEditMode="relative" rAng="0" ptsTypes="AA">
                                      <p:cBhvr>
                                        <p:cTn id="25" dur="40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1576" y="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" fill="hold">
                            <p:stCondLst>
                              <p:cond delay="5000"/>
                            </p:stCondLst>
                            <p:childTnLst>
                              <p:par>
                                <p:cTn id="27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0496" grpId="0" animBg="1"/>
      <p:bldP spid="12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Widescreen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Merletti</dc:creator>
  <cp:lastModifiedBy>Roberto Merletti</cp:lastModifiedBy>
  <cp:revision>1</cp:revision>
  <dcterms:created xsi:type="dcterms:W3CDTF">2022-03-09T18:01:24Z</dcterms:created>
  <dcterms:modified xsi:type="dcterms:W3CDTF">2022-03-09T18:03:20Z</dcterms:modified>
</cp:coreProperties>
</file>